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73152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04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902" y="67"/>
      </p:cViewPr>
      <p:guideLst>
        <p:guide orient="horz" pos="230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chen\Dropbox\IEG\Casey_May6\Manuscripts\ISME\revision\renamed_Galaxy153_UPARSE_0.97_otu_table.new%20calculation%20of%20shift.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9280582877337409E-2"/>
          <c:y val="2.3430205576992713E-2"/>
          <c:w val="0.91020102091110899"/>
          <c:h val="0.51222471395274605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saliva-7'!$A$1</c:f>
              <c:strCache>
                <c:ptCount val="1"/>
                <c:pt idx="0">
                  <c:v>Prevotell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'saliva-7'!$B$1:$BB$1</c:f>
              <c:numCache>
                <c:formatCode>0.0%</c:formatCode>
                <c:ptCount val="53"/>
                <c:pt idx="0">
                  <c:v>3.6646064650221515E-2</c:v>
                </c:pt>
                <c:pt idx="1">
                  <c:v>6.3141240770927226E-2</c:v>
                </c:pt>
                <c:pt idx="3">
                  <c:v>3.3676998157784167E-2</c:v>
                </c:pt>
                <c:pt idx="4">
                  <c:v>5.5743449737174523E-2</c:v>
                </c:pt>
                <c:pt idx="6">
                  <c:v>0.34316970546984571</c:v>
                </c:pt>
                <c:pt idx="7">
                  <c:v>5.4140343726649005E-2</c:v>
                </c:pt>
                <c:pt idx="9">
                  <c:v>9.945241199478487E-2</c:v>
                </c:pt>
                <c:pt idx="10">
                  <c:v>7.6321875747667273E-2</c:v>
                </c:pt>
                <c:pt idx="12">
                  <c:v>6.6663044659350218E-2</c:v>
                </c:pt>
                <c:pt idx="13">
                  <c:v>0.16900342949364536</c:v>
                </c:pt>
                <c:pt idx="15">
                  <c:v>9.3889603997879909E-3</c:v>
                </c:pt>
                <c:pt idx="16">
                  <c:v>0.13368564468849345</c:v>
                </c:pt>
                <c:pt idx="18">
                  <c:v>6.9380768995659883E-2</c:v>
                </c:pt>
                <c:pt idx="19">
                  <c:v>4.3298590385233482E-2</c:v>
                </c:pt>
                <c:pt idx="21">
                  <c:v>0.16462628865979381</c:v>
                </c:pt>
                <c:pt idx="22">
                  <c:v>0.26745113681691263</c:v>
                </c:pt>
                <c:pt idx="24">
                  <c:v>0.18817521115694363</c:v>
                </c:pt>
                <c:pt idx="25">
                  <c:v>6.1394082670678418E-2</c:v>
                </c:pt>
                <c:pt idx="27">
                  <c:v>1.4660254421346572E-2</c:v>
                </c:pt>
                <c:pt idx="28">
                  <c:v>5.4198841698841697E-2</c:v>
                </c:pt>
                <c:pt idx="30">
                  <c:v>5.0055741360089188E-2</c:v>
                </c:pt>
                <c:pt idx="31">
                  <c:v>0.2419193324061196</c:v>
                </c:pt>
                <c:pt idx="33">
                  <c:v>0.23258724256292906</c:v>
                </c:pt>
                <c:pt idx="34">
                  <c:v>0.40665674262376428</c:v>
                </c:pt>
                <c:pt idx="36">
                  <c:v>0.18366815123661517</c:v>
                </c:pt>
                <c:pt idx="37">
                  <c:v>0.25496646438837434</c:v>
                </c:pt>
                <c:pt idx="39">
                  <c:v>0.20958253374020827</c:v>
                </c:pt>
                <c:pt idx="40">
                  <c:v>8.8939997253878897E-2</c:v>
                </c:pt>
                <c:pt idx="42">
                  <c:v>0.28078507186685719</c:v>
                </c:pt>
                <c:pt idx="43">
                  <c:v>6.4249443954844943E-2</c:v>
                </c:pt>
                <c:pt idx="45">
                  <c:v>0.18738358375760586</c:v>
                </c:pt>
                <c:pt idx="46">
                  <c:v>8.3551967709384459E-2</c:v>
                </c:pt>
                <c:pt idx="48">
                  <c:v>7.4432180972361581E-2</c:v>
                </c:pt>
                <c:pt idx="49">
                  <c:v>8.3371633422189534E-2</c:v>
                </c:pt>
                <c:pt idx="51">
                  <c:v>9.021479713603818E-2</c:v>
                </c:pt>
                <c:pt idx="52">
                  <c:v>0.1497555012224939</c:v>
                </c:pt>
              </c:numCache>
            </c:numRef>
          </c:val>
        </c:ser>
        <c:ser>
          <c:idx val="1"/>
          <c:order val="1"/>
          <c:tx>
            <c:strRef>
              <c:f>'saliva-7'!$A$2</c:f>
              <c:strCache>
                <c:ptCount val="1"/>
                <c:pt idx="0">
                  <c:v>Streptococc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'saliva-7'!$B$2:$BB$2</c:f>
              <c:numCache>
                <c:formatCode>0.0%</c:formatCode>
                <c:ptCount val="53"/>
                <c:pt idx="0">
                  <c:v>0.16507137778263961</c:v>
                </c:pt>
                <c:pt idx="1">
                  <c:v>0.19436187553936141</c:v>
                </c:pt>
                <c:pt idx="3">
                  <c:v>9.298342005752884E-2</c:v>
                </c:pt>
                <c:pt idx="4">
                  <c:v>6.5156269100688641E-2</c:v>
                </c:pt>
                <c:pt idx="6">
                  <c:v>9.279102384291725E-2</c:v>
                </c:pt>
                <c:pt idx="7">
                  <c:v>0.54520752666259087</c:v>
                </c:pt>
                <c:pt idx="9">
                  <c:v>8.7249022164276407E-2</c:v>
                </c:pt>
                <c:pt idx="10">
                  <c:v>0.33284153441263259</c:v>
                </c:pt>
                <c:pt idx="12">
                  <c:v>0.24959252417689884</c:v>
                </c:pt>
                <c:pt idx="13">
                  <c:v>0.29589469437159571</c:v>
                </c:pt>
                <c:pt idx="15">
                  <c:v>0.10108275914287877</c:v>
                </c:pt>
                <c:pt idx="16">
                  <c:v>0.12765781759630074</c:v>
                </c:pt>
                <c:pt idx="18">
                  <c:v>0.11192615685555352</c:v>
                </c:pt>
                <c:pt idx="19">
                  <c:v>4.3023095642591484E-2</c:v>
                </c:pt>
                <c:pt idx="21">
                  <c:v>6.6956615120274912E-2</c:v>
                </c:pt>
                <c:pt idx="22">
                  <c:v>0.25752891902672514</c:v>
                </c:pt>
                <c:pt idx="24">
                  <c:v>0.12695606626072153</c:v>
                </c:pt>
                <c:pt idx="25">
                  <c:v>0.13826205315567017</c:v>
                </c:pt>
                <c:pt idx="27">
                  <c:v>0.1031647533354018</c:v>
                </c:pt>
                <c:pt idx="28">
                  <c:v>3.4218146718146721E-2</c:v>
                </c:pt>
                <c:pt idx="30">
                  <c:v>0.35031586770717205</c:v>
                </c:pt>
                <c:pt idx="31">
                  <c:v>7.3045897079276778E-2</c:v>
                </c:pt>
                <c:pt idx="33">
                  <c:v>6.4180491990846689E-2</c:v>
                </c:pt>
                <c:pt idx="34">
                  <c:v>0.11809611053857018</c:v>
                </c:pt>
                <c:pt idx="36">
                  <c:v>4.4323888941533211E-2</c:v>
                </c:pt>
                <c:pt idx="37">
                  <c:v>0.11226445225167678</c:v>
                </c:pt>
                <c:pt idx="39">
                  <c:v>0.24009815333312359</c:v>
                </c:pt>
                <c:pt idx="40">
                  <c:v>0.25171632568996294</c:v>
                </c:pt>
                <c:pt idx="42">
                  <c:v>3.7278305455156764E-2</c:v>
                </c:pt>
                <c:pt idx="43">
                  <c:v>0.41126358638633598</c:v>
                </c:pt>
                <c:pt idx="45">
                  <c:v>4.2127157581025705E-2</c:v>
                </c:pt>
                <c:pt idx="46">
                  <c:v>0.28947191389169191</c:v>
                </c:pt>
                <c:pt idx="48">
                  <c:v>6.9415306029371529E-2</c:v>
                </c:pt>
                <c:pt idx="49">
                  <c:v>3.5328001960964549E-2</c:v>
                </c:pt>
                <c:pt idx="51">
                  <c:v>0.21818615751789977</c:v>
                </c:pt>
                <c:pt idx="52">
                  <c:v>9.1270282284952209E-2</c:v>
                </c:pt>
              </c:numCache>
            </c:numRef>
          </c:val>
        </c:ser>
        <c:ser>
          <c:idx val="2"/>
          <c:order val="2"/>
          <c:tx>
            <c:strRef>
              <c:f>'saliva-7'!$A$3</c:f>
              <c:strCache>
                <c:ptCount val="1"/>
                <c:pt idx="0">
                  <c:v>Neisseri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'saliva-7'!$B$3:$BB$3</c:f>
              <c:numCache>
                <c:formatCode>0.0%</c:formatCode>
                <c:ptCount val="53"/>
                <c:pt idx="0">
                  <c:v>0.17092380900289886</c:v>
                </c:pt>
                <c:pt idx="1">
                  <c:v>0.15519225237319015</c:v>
                </c:pt>
                <c:pt idx="3">
                  <c:v>0.40166769011990561</c:v>
                </c:pt>
                <c:pt idx="4">
                  <c:v>0.32411067193675891</c:v>
                </c:pt>
                <c:pt idx="6">
                  <c:v>1.6100981767180927E-2</c:v>
                </c:pt>
                <c:pt idx="7">
                  <c:v>4.5513212417634674E-2</c:v>
                </c:pt>
                <c:pt idx="9">
                  <c:v>2.3989569752281615E-3</c:v>
                </c:pt>
                <c:pt idx="10">
                  <c:v>2.5520376425552278E-3</c:v>
                </c:pt>
                <c:pt idx="12">
                  <c:v>0.17336738020210801</c:v>
                </c:pt>
                <c:pt idx="13">
                  <c:v>3.5807948355860403E-2</c:v>
                </c:pt>
                <c:pt idx="15">
                  <c:v>6.1936851669569165E-2</c:v>
                </c:pt>
                <c:pt idx="16">
                  <c:v>8.860080095784649E-2</c:v>
                </c:pt>
                <c:pt idx="18">
                  <c:v>2.85469771990953E-2</c:v>
                </c:pt>
                <c:pt idx="19">
                  <c:v>0.31484457504935948</c:v>
                </c:pt>
                <c:pt idx="21">
                  <c:v>5.7345360824742266E-2</c:v>
                </c:pt>
                <c:pt idx="22">
                  <c:v>4.2331471878739528E-2</c:v>
                </c:pt>
                <c:pt idx="24">
                  <c:v>9.9063707195704842E-2</c:v>
                </c:pt>
                <c:pt idx="25">
                  <c:v>0.14553334766100723</c:v>
                </c:pt>
                <c:pt idx="27">
                  <c:v>1.3962147067949117E-3</c:v>
                </c:pt>
                <c:pt idx="28">
                  <c:v>1.4478764478764478E-4</c:v>
                </c:pt>
                <c:pt idx="30">
                  <c:v>0.1027870680044593</c:v>
                </c:pt>
                <c:pt idx="31">
                  <c:v>4.9735744089012518E-2</c:v>
                </c:pt>
                <c:pt idx="33">
                  <c:v>3.2894736842105261E-2</c:v>
                </c:pt>
                <c:pt idx="34">
                  <c:v>1.0076720485514714E-2</c:v>
                </c:pt>
                <c:pt idx="36">
                  <c:v>0.14863072112195586</c:v>
                </c:pt>
                <c:pt idx="37">
                  <c:v>4.5448738422229316E-2</c:v>
                </c:pt>
                <c:pt idx="39">
                  <c:v>8.0127095982634414E-2</c:v>
                </c:pt>
                <c:pt idx="40">
                  <c:v>0.11695043251407387</c:v>
                </c:pt>
                <c:pt idx="42">
                  <c:v>6.3671513827015219E-2</c:v>
                </c:pt>
                <c:pt idx="43">
                  <c:v>5.8835872256494184E-2</c:v>
                </c:pt>
                <c:pt idx="45">
                  <c:v>6.8297528871228113E-4</c:v>
                </c:pt>
                <c:pt idx="46">
                  <c:v>1.6818028927009755E-3</c:v>
                </c:pt>
                <c:pt idx="48">
                  <c:v>0.55212989145306945</c:v>
                </c:pt>
                <c:pt idx="49">
                  <c:v>0.498667156907804</c:v>
                </c:pt>
                <c:pt idx="51">
                  <c:v>4.696897374701671E-2</c:v>
                </c:pt>
                <c:pt idx="52">
                  <c:v>8.0990220048899761E-2</c:v>
                </c:pt>
              </c:numCache>
            </c:numRef>
          </c:val>
        </c:ser>
        <c:ser>
          <c:idx val="3"/>
          <c:order val="3"/>
          <c:tx>
            <c:strRef>
              <c:f>'saliva-7'!$A$4</c:f>
              <c:strCache>
                <c:ptCount val="1"/>
                <c:pt idx="0">
                  <c:v>Fusobacterium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'saliva-7'!$B$4:$BB$4</c:f>
              <c:numCache>
                <c:formatCode>0.0%</c:formatCode>
                <c:ptCount val="53"/>
                <c:pt idx="0">
                  <c:v>8.3137340699010007E-2</c:v>
                </c:pt>
                <c:pt idx="1">
                  <c:v>0.1269057435995781</c:v>
                </c:pt>
                <c:pt idx="3">
                  <c:v>0.11874212210335801</c:v>
                </c:pt>
                <c:pt idx="4">
                  <c:v>0.12297787376227537</c:v>
                </c:pt>
                <c:pt idx="6">
                  <c:v>1.5035063113604488E-2</c:v>
                </c:pt>
                <c:pt idx="7">
                  <c:v>1.7661843624753753E-3</c:v>
                </c:pt>
                <c:pt idx="9">
                  <c:v>0.14091264667535855</c:v>
                </c:pt>
                <c:pt idx="10">
                  <c:v>0.10295876864183746</c:v>
                </c:pt>
                <c:pt idx="12">
                  <c:v>0.10366184939693578</c:v>
                </c:pt>
                <c:pt idx="13">
                  <c:v>5.8452693161186203E-2</c:v>
                </c:pt>
                <c:pt idx="15">
                  <c:v>4.0735973347467251E-2</c:v>
                </c:pt>
                <c:pt idx="16">
                  <c:v>2.9932703026299492E-2</c:v>
                </c:pt>
                <c:pt idx="18">
                  <c:v>4.3645699614890884E-2</c:v>
                </c:pt>
                <c:pt idx="19">
                  <c:v>6.4465769778226725E-2</c:v>
                </c:pt>
                <c:pt idx="21">
                  <c:v>7.6138316151202742E-2</c:v>
                </c:pt>
                <c:pt idx="22">
                  <c:v>4.711806940566414E-2</c:v>
                </c:pt>
                <c:pt idx="24">
                  <c:v>7.9290250769331494E-2</c:v>
                </c:pt>
                <c:pt idx="25">
                  <c:v>0.15165842825417294</c:v>
                </c:pt>
                <c:pt idx="27">
                  <c:v>8.6487744337573683E-2</c:v>
                </c:pt>
                <c:pt idx="28">
                  <c:v>4.0154440154440155E-2</c:v>
                </c:pt>
                <c:pt idx="30">
                  <c:v>6.2393162393162394E-2</c:v>
                </c:pt>
                <c:pt idx="31">
                  <c:v>9.2044506258692635E-2</c:v>
                </c:pt>
                <c:pt idx="33">
                  <c:v>0.10025743707093822</c:v>
                </c:pt>
                <c:pt idx="34">
                  <c:v>1.6641856559410664E-2</c:v>
                </c:pt>
                <c:pt idx="36">
                  <c:v>4.2025964180801671E-2</c:v>
                </c:pt>
                <c:pt idx="37">
                  <c:v>0.13925263494091344</c:v>
                </c:pt>
                <c:pt idx="39">
                  <c:v>2.3846226444773022E-2</c:v>
                </c:pt>
                <c:pt idx="40">
                  <c:v>1.4691747906082658E-2</c:v>
                </c:pt>
                <c:pt idx="42">
                  <c:v>6.4049760443809362E-2</c:v>
                </c:pt>
                <c:pt idx="43">
                  <c:v>2.9963489865290193E-2</c:v>
                </c:pt>
                <c:pt idx="45">
                  <c:v>0.18629703216192722</c:v>
                </c:pt>
                <c:pt idx="46">
                  <c:v>3.8378742011436262E-2</c:v>
                </c:pt>
                <c:pt idx="48">
                  <c:v>1.131077259874122E-2</c:v>
                </c:pt>
                <c:pt idx="49">
                  <c:v>1.2041547936391213E-2</c:v>
                </c:pt>
                <c:pt idx="51">
                  <c:v>5.9809069212410498E-2</c:v>
                </c:pt>
                <c:pt idx="52">
                  <c:v>3.5619026450322291E-2</c:v>
                </c:pt>
              </c:numCache>
            </c:numRef>
          </c:val>
        </c:ser>
        <c:ser>
          <c:idx val="4"/>
          <c:order val="4"/>
          <c:tx>
            <c:strRef>
              <c:f>'saliva-7'!$A$5</c:f>
              <c:strCache>
                <c:ptCount val="1"/>
                <c:pt idx="0">
                  <c:v>Veillonell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'saliva-7'!$B$5:$BB$5</c:f>
              <c:numCache>
                <c:formatCode>0.0%</c:formatCode>
                <c:ptCount val="53"/>
                <c:pt idx="0">
                  <c:v>1.9526335940491166E-2</c:v>
                </c:pt>
                <c:pt idx="1">
                  <c:v>4.7895291974302423E-2</c:v>
                </c:pt>
                <c:pt idx="3">
                  <c:v>3.1349988688148409E-2</c:v>
                </c:pt>
                <c:pt idx="4">
                  <c:v>7.7339961696752377E-2</c:v>
                </c:pt>
                <c:pt idx="6">
                  <c:v>0.20762973352033662</c:v>
                </c:pt>
                <c:pt idx="7">
                  <c:v>2.9889273826506353E-3</c:v>
                </c:pt>
                <c:pt idx="9">
                  <c:v>3.1864406779661014E-2</c:v>
                </c:pt>
                <c:pt idx="10">
                  <c:v>0.17565196586649653</c:v>
                </c:pt>
                <c:pt idx="12">
                  <c:v>1.868955775290666E-2</c:v>
                </c:pt>
                <c:pt idx="13">
                  <c:v>5.1089368569699416E-2</c:v>
                </c:pt>
                <c:pt idx="15">
                  <c:v>4.3916105095782544E-3</c:v>
                </c:pt>
                <c:pt idx="16">
                  <c:v>0.21568060773708764</c:v>
                </c:pt>
                <c:pt idx="18">
                  <c:v>1.2653585182468365E-2</c:v>
                </c:pt>
                <c:pt idx="19">
                  <c:v>3.0625832223701729E-2</c:v>
                </c:pt>
                <c:pt idx="21">
                  <c:v>0.10846219931271478</c:v>
                </c:pt>
                <c:pt idx="22">
                  <c:v>3.8392500997207819E-2</c:v>
                </c:pt>
                <c:pt idx="24">
                  <c:v>7.7587900216067568E-2</c:v>
                </c:pt>
                <c:pt idx="25">
                  <c:v>3.9759295078444015E-3</c:v>
                </c:pt>
                <c:pt idx="27">
                  <c:v>6.9810735339745583E-4</c:v>
                </c:pt>
                <c:pt idx="28">
                  <c:v>7.1428571428571426E-3</c:v>
                </c:pt>
                <c:pt idx="30">
                  <c:v>4.7603121516164998E-2</c:v>
                </c:pt>
                <c:pt idx="31">
                  <c:v>0.14542420027816411</c:v>
                </c:pt>
                <c:pt idx="33">
                  <c:v>0.15095823798627003</c:v>
                </c:pt>
                <c:pt idx="34">
                  <c:v>0.12160769495018894</c:v>
                </c:pt>
                <c:pt idx="36">
                  <c:v>0.15576139486401971</c:v>
                </c:pt>
                <c:pt idx="37">
                  <c:v>5.8351964228680935E-2</c:v>
                </c:pt>
                <c:pt idx="39">
                  <c:v>3.8128794790323085E-2</c:v>
                </c:pt>
                <c:pt idx="40">
                  <c:v>3.5562268296031853E-2</c:v>
                </c:pt>
                <c:pt idx="42">
                  <c:v>9.351096915188703E-2</c:v>
                </c:pt>
                <c:pt idx="43">
                  <c:v>6.2319023039153973E-2</c:v>
                </c:pt>
                <c:pt idx="45">
                  <c:v>4.6069787656773872E-2</c:v>
                </c:pt>
                <c:pt idx="46">
                  <c:v>0.12869155734947865</c:v>
                </c:pt>
                <c:pt idx="48">
                  <c:v>2.8687403083097692E-2</c:v>
                </c:pt>
                <c:pt idx="49">
                  <c:v>2.4634617152311793E-2</c:v>
                </c:pt>
                <c:pt idx="51">
                  <c:v>0.10272076372315035</c:v>
                </c:pt>
                <c:pt idx="52">
                  <c:v>0.18945876861524782</c:v>
                </c:pt>
              </c:numCache>
            </c:numRef>
          </c:val>
        </c:ser>
        <c:ser>
          <c:idx val="5"/>
          <c:order val="5"/>
          <c:tx>
            <c:strRef>
              <c:f>'saliva-7'!$A$6</c:f>
              <c:strCache>
                <c:ptCount val="1"/>
                <c:pt idx="0">
                  <c:v>Rothi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val>
            <c:numRef>
              <c:f>'saliva-7'!$B$6:$BB$6</c:f>
              <c:numCache>
                <c:formatCode>0.0%</c:formatCode>
                <c:ptCount val="53"/>
                <c:pt idx="0">
                  <c:v>3.9927801783077171E-3</c:v>
                </c:pt>
                <c:pt idx="1">
                  <c:v>6.836705340876402E-2</c:v>
                </c:pt>
                <c:pt idx="3">
                  <c:v>6.7547913771371319E-3</c:v>
                </c:pt>
                <c:pt idx="4">
                  <c:v>8.1903752903304677E-3</c:v>
                </c:pt>
                <c:pt idx="6">
                  <c:v>4.3927068723702667E-2</c:v>
                </c:pt>
                <c:pt idx="7">
                  <c:v>6.6979145438489235E-2</c:v>
                </c:pt>
                <c:pt idx="9">
                  <c:v>0.32735332464146022</c:v>
                </c:pt>
                <c:pt idx="10">
                  <c:v>7.2932450753648612E-2</c:v>
                </c:pt>
                <c:pt idx="12">
                  <c:v>6.1284363794414862E-2</c:v>
                </c:pt>
                <c:pt idx="13">
                  <c:v>6.9699414968731083E-2</c:v>
                </c:pt>
                <c:pt idx="15">
                  <c:v>1.2266222457787537E-2</c:v>
                </c:pt>
                <c:pt idx="16">
                  <c:v>4.2359935593080385E-2</c:v>
                </c:pt>
                <c:pt idx="18">
                  <c:v>3.2581453634085211E-2</c:v>
                </c:pt>
                <c:pt idx="19">
                  <c:v>0.10106065475917168</c:v>
                </c:pt>
                <c:pt idx="21">
                  <c:v>1.0362972508591065E-2</c:v>
                </c:pt>
                <c:pt idx="22">
                  <c:v>5.1605504587155966E-2</c:v>
                </c:pt>
                <c:pt idx="24">
                  <c:v>1.0737903489818634E-2</c:v>
                </c:pt>
                <c:pt idx="25">
                  <c:v>8.1667741242209321E-3</c:v>
                </c:pt>
                <c:pt idx="27">
                  <c:v>4.1110766366739063E-3</c:v>
                </c:pt>
                <c:pt idx="28">
                  <c:v>1.1583011583011582E-2</c:v>
                </c:pt>
                <c:pt idx="30">
                  <c:v>5.224823485693051E-2</c:v>
                </c:pt>
                <c:pt idx="31">
                  <c:v>3.0987482614742698E-2</c:v>
                </c:pt>
                <c:pt idx="33">
                  <c:v>4.9306350114416475E-2</c:v>
                </c:pt>
                <c:pt idx="34">
                  <c:v>9.9049582045116227E-2</c:v>
                </c:pt>
                <c:pt idx="36">
                  <c:v>7.8982279920401785E-2</c:v>
                </c:pt>
                <c:pt idx="37">
                  <c:v>1.5969338869370808E-2</c:v>
                </c:pt>
                <c:pt idx="39">
                  <c:v>2.8942649510806304E-2</c:v>
                </c:pt>
                <c:pt idx="40">
                  <c:v>0.2467733077028697</c:v>
                </c:pt>
                <c:pt idx="42">
                  <c:v>5.3374800369841137E-2</c:v>
                </c:pt>
                <c:pt idx="43">
                  <c:v>6.0430567795543247E-2</c:v>
                </c:pt>
                <c:pt idx="45">
                  <c:v>1.68260275673662E-2</c:v>
                </c:pt>
                <c:pt idx="46">
                  <c:v>7.5243861419441643E-2</c:v>
                </c:pt>
                <c:pt idx="48">
                  <c:v>9.3906777341968437E-2</c:v>
                </c:pt>
                <c:pt idx="49">
                  <c:v>9.1429972117535313E-2</c:v>
                </c:pt>
                <c:pt idx="51">
                  <c:v>5.326968973747017E-2</c:v>
                </c:pt>
                <c:pt idx="52">
                  <c:v>3.4979995554567683E-2</c:v>
                </c:pt>
              </c:numCache>
            </c:numRef>
          </c:val>
        </c:ser>
        <c:ser>
          <c:idx val="6"/>
          <c:order val="6"/>
          <c:tx>
            <c:strRef>
              <c:f>'saliva-7'!$A$7</c:f>
              <c:strCache>
                <c:ptCount val="1"/>
                <c:pt idx="0">
                  <c:v>Actinobacillus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7:$BB$7</c:f>
              <c:numCache>
                <c:formatCode>0.0%</c:formatCode>
                <c:ptCount val="53"/>
                <c:pt idx="0">
                  <c:v>7.1541869496253352E-2</c:v>
                </c:pt>
                <c:pt idx="1">
                  <c:v>8.9462076900949275E-2</c:v>
                </c:pt>
                <c:pt idx="3">
                  <c:v>4.6346271936912188E-2</c:v>
                </c:pt>
                <c:pt idx="4">
                  <c:v>3.7162299824783016E-2</c:v>
                </c:pt>
                <c:pt idx="6">
                  <c:v>6.1542776998597476E-2</c:v>
                </c:pt>
                <c:pt idx="7">
                  <c:v>2.3367977718904965E-2</c:v>
                </c:pt>
                <c:pt idx="9">
                  <c:v>5.8409387222946542E-3</c:v>
                </c:pt>
                <c:pt idx="10">
                  <c:v>4.6415184623973205E-2</c:v>
                </c:pt>
                <c:pt idx="12">
                  <c:v>1.8852548082147126E-2</c:v>
                </c:pt>
                <c:pt idx="13">
                  <c:v>5.5981440387331046E-3</c:v>
                </c:pt>
                <c:pt idx="15">
                  <c:v>1.1584765654577119E-2</c:v>
                </c:pt>
                <c:pt idx="16">
                  <c:v>7.8526898146236743E-2</c:v>
                </c:pt>
                <c:pt idx="18">
                  <c:v>2.60407115349349E-2</c:v>
                </c:pt>
                <c:pt idx="19">
                  <c:v>5.5604022223242573E-2</c:v>
                </c:pt>
                <c:pt idx="21">
                  <c:v>6.9158075601374575E-2</c:v>
                </c:pt>
                <c:pt idx="22">
                  <c:v>5.1156761069006781E-2</c:v>
                </c:pt>
                <c:pt idx="24">
                  <c:v>6.1153669874942709E-2</c:v>
                </c:pt>
                <c:pt idx="25">
                  <c:v>1.3002364066193853E-2</c:v>
                </c:pt>
                <c:pt idx="27">
                  <c:v>2.3270245113248526E-4</c:v>
                </c:pt>
                <c:pt idx="28">
                  <c:v>0</c:v>
                </c:pt>
                <c:pt idx="30">
                  <c:v>6.952805648457823E-2</c:v>
                </c:pt>
                <c:pt idx="31">
                  <c:v>1.52990264255911E-3</c:v>
                </c:pt>
                <c:pt idx="33">
                  <c:v>1.2550057208237986E-2</c:v>
                </c:pt>
                <c:pt idx="34">
                  <c:v>5.439138898431238E-2</c:v>
                </c:pt>
                <c:pt idx="36">
                  <c:v>6.3678574812849428E-2</c:v>
                </c:pt>
                <c:pt idx="37">
                  <c:v>3.8007026509102523E-2</c:v>
                </c:pt>
                <c:pt idx="39">
                  <c:v>9.0540157926196241E-2</c:v>
                </c:pt>
                <c:pt idx="40">
                  <c:v>3.9509817382946587E-2</c:v>
                </c:pt>
                <c:pt idx="42">
                  <c:v>0.13314280911154072</c:v>
                </c:pt>
                <c:pt idx="43">
                  <c:v>1.410046581896009E-2</c:v>
                </c:pt>
                <c:pt idx="45">
                  <c:v>6.8297528871228115E-3</c:v>
                </c:pt>
                <c:pt idx="46">
                  <c:v>2.9364278506559031E-2</c:v>
                </c:pt>
                <c:pt idx="48">
                  <c:v>1.1630028276931497E-2</c:v>
                </c:pt>
                <c:pt idx="49">
                  <c:v>2.9874069307840794E-2</c:v>
                </c:pt>
                <c:pt idx="51">
                  <c:v>0.11971360381861575</c:v>
                </c:pt>
                <c:pt idx="52">
                  <c:v>0.26911535896865968</c:v>
                </c:pt>
              </c:numCache>
            </c:numRef>
          </c:val>
        </c:ser>
        <c:ser>
          <c:idx val="7"/>
          <c:order val="7"/>
          <c:tx>
            <c:strRef>
              <c:f>'saliva-7'!$A$8</c:f>
              <c:strCache>
                <c:ptCount val="1"/>
                <c:pt idx="0">
                  <c:v>Porphyromona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8:$BB$8</c:f>
              <c:numCache>
                <c:formatCode>0.0%</c:formatCode>
                <c:ptCount val="53"/>
                <c:pt idx="0">
                  <c:v>3.6481977793578736E-2</c:v>
                </c:pt>
                <c:pt idx="1">
                  <c:v>1.5198005561415285E-2</c:v>
                </c:pt>
                <c:pt idx="3">
                  <c:v>2.5855660773730651E-3</c:v>
                </c:pt>
                <c:pt idx="4">
                  <c:v>4.3600505276883582E-3</c:v>
                </c:pt>
                <c:pt idx="6">
                  <c:v>1.1107994389901824E-2</c:v>
                </c:pt>
                <c:pt idx="7">
                  <c:v>2.6492765437130632E-3</c:v>
                </c:pt>
                <c:pt idx="9">
                  <c:v>0.10148631029986963</c:v>
                </c:pt>
                <c:pt idx="10">
                  <c:v>1.1205040274344047E-2</c:v>
                </c:pt>
                <c:pt idx="12">
                  <c:v>3.6075192871889601E-2</c:v>
                </c:pt>
                <c:pt idx="13">
                  <c:v>9.2798063344764984E-3</c:v>
                </c:pt>
                <c:pt idx="15">
                  <c:v>1.9459377602786401E-2</c:v>
                </c:pt>
                <c:pt idx="16">
                  <c:v>8.917881177490608E-3</c:v>
                </c:pt>
                <c:pt idx="18">
                  <c:v>7.5493612078977937E-2</c:v>
                </c:pt>
                <c:pt idx="19">
                  <c:v>5.4823453785756919E-2</c:v>
                </c:pt>
                <c:pt idx="21">
                  <c:v>4.0055841924398629E-2</c:v>
                </c:pt>
                <c:pt idx="22">
                  <c:v>6.6314319904268049E-3</c:v>
                </c:pt>
                <c:pt idx="24">
                  <c:v>4.5243239704052904E-2</c:v>
                </c:pt>
                <c:pt idx="25">
                  <c:v>3.4995343505981803E-2</c:v>
                </c:pt>
                <c:pt idx="27">
                  <c:v>1.0083772882407695E-2</c:v>
                </c:pt>
                <c:pt idx="28">
                  <c:v>2.2007722007722007E-2</c:v>
                </c:pt>
                <c:pt idx="30">
                  <c:v>7.5436640654031962E-3</c:v>
                </c:pt>
                <c:pt idx="31">
                  <c:v>2.086230876216968E-3</c:v>
                </c:pt>
                <c:pt idx="33">
                  <c:v>6.6862128146453093E-2</c:v>
                </c:pt>
                <c:pt idx="34">
                  <c:v>6.3742890950036265E-3</c:v>
                </c:pt>
                <c:pt idx="36">
                  <c:v>1.1963422723396192E-2</c:v>
                </c:pt>
                <c:pt idx="37">
                  <c:v>1.4595975726604919E-2</c:v>
                </c:pt>
                <c:pt idx="39">
                  <c:v>1.0884952968194545E-2</c:v>
                </c:pt>
                <c:pt idx="40">
                  <c:v>1.0297954139777564E-3</c:v>
                </c:pt>
                <c:pt idx="42">
                  <c:v>7.9053542909977306E-2</c:v>
                </c:pt>
                <c:pt idx="43">
                  <c:v>8.0154433673255282E-3</c:v>
                </c:pt>
                <c:pt idx="45">
                  <c:v>9.4840432137091771E-2</c:v>
                </c:pt>
                <c:pt idx="46">
                  <c:v>2.3410696266397579E-2</c:v>
                </c:pt>
                <c:pt idx="48">
                  <c:v>8.2094317248928208E-3</c:v>
                </c:pt>
                <c:pt idx="49">
                  <c:v>3.7074486012807551E-3</c:v>
                </c:pt>
                <c:pt idx="51">
                  <c:v>3.7326968973747016E-2</c:v>
                </c:pt>
                <c:pt idx="52">
                  <c:v>7.2238275172260499E-4</c:v>
                </c:pt>
              </c:numCache>
            </c:numRef>
          </c:val>
        </c:ser>
        <c:ser>
          <c:idx val="8"/>
          <c:order val="8"/>
          <c:tx>
            <c:strRef>
              <c:f>'saliva-7'!$A$9</c:f>
              <c:strCache>
                <c:ptCount val="1"/>
                <c:pt idx="0">
                  <c:v>Treponem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9:$BB$9</c:f>
              <c:numCache>
                <c:formatCode>0.0%</c:formatCode>
                <c:ptCount val="53"/>
                <c:pt idx="0">
                  <c:v>4.2771973964885412E-2</c:v>
                </c:pt>
                <c:pt idx="1">
                  <c:v>5.8490746955604566E-3</c:v>
                </c:pt>
                <c:pt idx="3">
                  <c:v>5.4943279144177625E-4</c:v>
                </c:pt>
                <c:pt idx="4">
                  <c:v>1.1409478016380752E-3</c:v>
                </c:pt>
                <c:pt idx="6">
                  <c:v>1.3464235624123422E-3</c:v>
                </c:pt>
                <c:pt idx="7">
                  <c:v>1.3586033557502888E-4</c:v>
                </c:pt>
                <c:pt idx="9">
                  <c:v>2.4093872229465449E-2</c:v>
                </c:pt>
                <c:pt idx="10">
                  <c:v>2.2729085254007495E-3</c:v>
                </c:pt>
                <c:pt idx="12">
                  <c:v>6.6826034988590674E-3</c:v>
                </c:pt>
                <c:pt idx="13">
                  <c:v>1.9164817429897115E-3</c:v>
                </c:pt>
                <c:pt idx="15">
                  <c:v>2.6425380480048458E-2</c:v>
                </c:pt>
                <c:pt idx="16">
                  <c:v>4.0873622063498614E-3</c:v>
                </c:pt>
                <c:pt idx="18">
                  <c:v>6.2106485726511403E-2</c:v>
                </c:pt>
                <c:pt idx="19">
                  <c:v>1.3958400293861058E-2</c:v>
                </c:pt>
                <c:pt idx="21">
                  <c:v>1.7396907216494846E-2</c:v>
                </c:pt>
                <c:pt idx="22">
                  <c:v>2.0442760271240528E-3</c:v>
                </c:pt>
                <c:pt idx="24">
                  <c:v>1.0476003404701107E-3</c:v>
                </c:pt>
                <c:pt idx="25">
                  <c:v>1.246507629486353E-2</c:v>
                </c:pt>
                <c:pt idx="27">
                  <c:v>4.5764815389388765E-3</c:v>
                </c:pt>
                <c:pt idx="28">
                  <c:v>3.3783783783783786E-4</c:v>
                </c:pt>
                <c:pt idx="30">
                  <c:v>1.9323671497584541E-3</c:v>
                </c:pt>
                <c:pt idx="31">
                  <c:v>8.8456189151599439E-3</c:v>
                </c:pt>
                <c:pt idx="33">
                  <c:v>1.6840675057208238E-2</c:v>
                </c:pt>
                <c:pt idx="34">
                  <c:v>2.9390434749417917E-3</c:v>
                </c:pt>
                <c:pt idx="36">
                  <c:v>5.9698663887046335E-3</c:v>
                </c:pt>
                <c:pt idx="37">
                  <c:v>8.6234429894602362E-3</c:v>
                </c:pt>
                <c:pt idx="39">
                  <c:v>3.4668260609683206E-2</c:v>
                </c:pt>
                <c:pt idx="40">
                  <c:v>1.6476726623644103E-3</c:v>
                </c:pt>
                <c:pt idx="42">
                  <c:v>4.1607127847356476E-3</c:v>
                </c:pt>
                <c:pt idx="43">
                  <c:v>2.6858030131352555E-3</c:v>
                </c:pt>
                <c:pt idx="45">
                  <c:v>5.7400968583136716E-2</c:v>
                </c:pt>
                <c:pt idx="46">
                  <c:v>1.0191725529767911E-2</c:v>
                </c:pt>
                <c:pt idx="48">
                  <c:v>2.4628295174678465E-3</c:v>
                </c:pt>
                <c:pt idx="49">
                  <c:v>1.7158439807580354E-3</c:v>
                </c:pt>
                <c:pt idx="51">
                  <c:v>9.5465393794749408E-5</c:v>
                </c:pt>
                <c:pt idx="52">
                  <c:v>2.7783951989330962E-5</c:v>
                </c:pt>
              </c:numCache>
            </c:numRef>
          </c:val>
        </c:ser>
        <c:ser>
          <c:idx val="9"/>
          <c:order val="9"/>
          <c:tx>
            <c:strRef>
              <c:f>'saliva-7'!$A$10</c:f>
              <c:strCache>
                <c:ptCount val="1"/>
                <c:pt idx="0">
                  <c:v>Lactobacillu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10:$BB$10</c:f>
              <c:numCache>
                <c:formatCode>0.0%</c:formatCode>
                <c:ptCount val="53"/>
                <c:pt idx="0">
                  <c:v>0</c:v>
                </c:pt>
                <c:pt idx="1">
                  <c:v>0</c:v>
                </c:pt>
                <c:pt idx="3">
                  <c:v>0</c:v>
                </c:pt>
                <c:pt idx="4">
                  <c:v>0</c:v>
                </c:pt>
                <c:pt idx="6">
                  <c:v>0</c:v>
                </c:pt>
                <c:pt idx="7">
                  <c:v>0</c:v>
                </c:pt>
                <c:pt idx="9">
                  <c:v>2.0860495436766623E-4</c:v>
                </c:pt>
                <c:pt idx="10">
                  <c:v>3.9875588164925435E-5</c:v>
                </c:pt>
                <c:pt idx="12">
                  <c:v>0</c:v>
                </c:pt>
                <c:pt idx="13">
                  <c:v>5.0433730078676621E-5</c:v>
                </c:pt>
                <c:pt idx="15">
                  <c:v>7.5717422578935406E-5</c:v>
                </c:pt>
                <c:pt idx="16">
                  <c:v>7.4315676479088397E-4</c:v>
                </c:pt>
                <c:pt idx="18">
                  <c:v>2.4451372333272203E-4</c:v>
                </c:pt>
                <c:pt idx="19">
                  <c:v>4.5915790440332433E-5</c:v>
                </c:pt>
                <c:pt idx="21">
                  <c:v>0</c:v>
                </c:pt>
                <c:pt idx="22">
                  <c:v>4.9860390905464696E-5</c:v>
                </c:pt>
                <c:pt idx="24">
                  <c:v>0</c:v>
                </c:pt>
                <c:pt idx="25">
                  <c:v>0</c:v>
                </c:pt>
                <c:pt idx="27">
                  <c:v>0.53312131554452369</c:v>
                </c:pt>
                <c:pt idx="28">
                  <c:v>0.72331081081081083</c:v>
                </c:pt>
                <c:pt idx="30">
                  <c:v>0</c:v>
                </c:pt>
                <c:pt idx="31">
                  <c:v>0</c:v>
                </c:pt>
                <c:pt idx="33">
                  <c:v>3.5755148741418764E-5</c:v>
                </c:pt>
                <c:pt idx="34">
                  <c:v>0</c:v>
                </c:pt>
                <c:pt idx="36">
                  <c:v>0</c:v>
                </c:pt>
                <c:pt idx="37">
                  <c:v>0</c:v>
                </c:pt>
                <c:pt idx="39">
                  <c:v>6.2918803284361537E-5</c:v>
                </c:pt>
                <c:pt idx="40">
                  <c:v>1.0297954139777564E-4</c:v>
                </c:pt>
                <c:pt idx="42">
                  <c:v>0</c:v>
                </c:pt>
                <c:pt idx="43">
                  <c:v>0</c:v>
                </c:pt>
                <c:pt idx="45">
                  <c:v>6.2088662610207377E-5</c:v>
                </c:pt>
                <c:pt idx="46">
                  <c:v>1.6818028927009755E-4</c:v>
                </c:pt>
                <c:pt idx="48">
                  <c:v>1.3682386208154702E-4</c:v>
                </c:pt>
                <c:pt idx="49">
                  <c:v>0</c:v>
                </c:pt>
                <c:pt idx="51">
                  <c:v>0</c:v>
                </c:pt>
                <c:pt idx="52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saliva-7'!$A$11</c:f>
              <c:strCache>
                <c:ptCount val="1"/>
                <c:pt idx="0">
                  <c:v>Leptotrichi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11:$BB$11</c:f>
              <c:numCache>
                <c:formatCode>0.0%</c:formatCode>
                <c:ptCount val="53"/>
                <c:pt idx="0">
                  <c:v>5.79773560137833E-3</c:v>
                </c:pt>
                <c:pt idx="1">
                  <c:v>1.1170773803816281E-2</c:v>
                </c:pt>
                <c:pt idx="3">
                  <c:v>2.5532465014059015E-3</c:v>
                </c:pt>
                <c:pt idx="4">
                  <c:v>1.727720956766228E-2</c:v>
                </c:pt>
                <c:pt idx="6">
                  <c:v>3.8709677419354839E-3</c:v>
                </c:pt>
                <c:pt idx="7">
                  <c:v>2.037905033625433E-4</c:v>
                </c:pt>
                <c:pt idx="9">
                  <c:v>1.5645371577574967E-3</c:v>
                </c:pt>
                <c:pt idx="10">
                  <c:v>4.3863146981417975E-3</c:v>
                </c:pt>
                <c:pt idx="12">
                  <c:v>8.2581766815168975E-3</c:v>
                </c:pt>
                <c:pt idx="13">
                  <c:v>1.2911034900141215E-2</c:v>
                </c:pt>
                <c:pt idx="15">
                  <c:v>4.4673279321571892E-3</c:v>
                </c:pt>
                <c:pt idx="16">
                  <c:v>7.8857190041699346E-3</c:v>
                </c:pt>
                <c:pt idx="18">
                  <c:v>2.0355767467449111E-2</c:v>
                </c:pt>
                <c:pt idx="19">
                  <c:v>1.1800358143165435E-2</c:v>
                </c:pt>
                <c:pt idx="21">
                  <c:v>6.9104381443298973E-2</c:v>
                </c:pt>
                <c:pt idx="22">
                  <c:v>1.0221380135620264E-2</c:v>
                </c:pt>
                <c:pt idx="24">
                  <c:v>3.8433837490997186E-2</c:v>
                </c:pt>
                <c:pt idx="25">
                  <c:v>9.8431119707715453E-2</c:v>
                </c:pt>
                <c:pt idx="27">
                  <c:v>4.6540490226497052E-4</c:v>
                </c:pt>
                <c:pt idx="28">
                  <c:v>4.8262548262548262E-5</c:v>
                </c:pt>
                <c:pt idx="30">
                  <c:v>4.0208101077666293E-2</c:v>
                </c:pt>
                <c:pt idx="31">
                  <c:v>9.1655076495132132E-2</c:v>
                </c:pt>
                <c:pt idx="33">
                  <c:v>1.8521167048054919E-2</c:v>
                </c:pt>
                <c:pt idx="34">
                  <c:v>4.7711744723081036E-3</c:v>
                </c:pt>
                <c:pt idx="36">
                  <c:v>2.7669856912726238E-2</c:v>
                </c:pt>
                <c:pt idx="37">
                  <c:v>1.0827211753433407E-2</c:v>
                </c:pt>
                <c:pt idx="39">
                  <c:v>8.682794853241891E-3</c:v>
                </c:pt>
                <c:pt idx="40">
                  <c:v>1.2941095702320472E-2</c:v>
                </c:pt>
                <c:pt idx="42">
                  <c:v>4.4128771959317473E-3</c:v>
                </c:pt>
                <c:pt idx="43">
                  <c:v>4.7001552729866967E-3</c:v>
                </c:pt>
                <c:pt idx="45">
                  <c:v>6.5813982366819818E-3</c:v>
                </c:pt>
                <c:pt idx="46">
                  <c:v>1.7827110662630339E-3</c:v>
                </c:pt>
                <c:pt idx="48">
                  <c:v>1.3956033932317796E-2</c:v>
                </c:pt>
                <c:pt idx="49">
                  <c:v>7.0686643993014067E-2</c:v>
                </c:pt>
                <c:pt idx="51">
                  <c:v>9.5465393794749408E-3</c:v>
                </c:pt>
                <c:pt idx="52">
                  <c:v>1.6837074905534564E-2</c:v>
                </c:pt>
              </c:numCache>
            </c:numRef>
          </c:val>
        </c:ser>
        <c:ser>
          <c:idx val="11"/>
          <c:order val="11"/>
          <c:tx>
            <c:strRef>
              <c:f>'saliva-7'!$A$12</c:f>
              <c:strCache>
                <c:ptCount val="1"/>
                <c:pt idx="0">
                  <c:v>Campylobacter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12:$BB$12</c:f>
              <c:numCache>
                <c:formatCode>0.0%</c:formatCode>
                <c:ptCount val="53"/>
                <c:pt idx="0">
                  <c:v>1.947164032161024E-2</c:v>
                </c:pt>
                <c:pt idx="1">
                  <c:v>1.8937577907757214E-2</c:v>
                </c:pt>
                <c:pt idx="3">
                  <c:v>6.9810284089072755E-3</c:v>
                </c:pt>
                <c:pt idx="4">
                  <c:v>1.7643942789617374E-2</c:v>
                </c:pt>
                <c:pt idx="6">
                  <c:v>2.0981767180925665E-2</c:v>
                </c:pt>
                <c:pt idx="7">
                  <c:v>5.162692751851097E-3</c:v>
                </c:pt>
                <c:pt idx="9">
                  <c:v>9.700130378096479E-3</c:v>
                </c:pt>
                <c:pt idx="10">
                  <c:v>1.0048648217561209E-2</c:v>
                </c:pt>
                <c:pt idx="12">
                  <c:v>1.2713245680756276E-2</c:v>
                </c:pt>
                <c:pt idx="13">
                  <c:v>5.4972765785757513E-3</c:v>
                </c:pt>
                <c:pt idx="15">
                  <c:v>1.6733550389944726E-2</c:v>
                </c:pt>
                <c:pt idx="16">
                  <c:v>7.3077081871103589E-3</c:v>
                </c:pt>
                <c:pt idx="18">
                  <c:v>7.7633107158139253E-3</c:v>
                </c:pt>
                <c:pt idx="19">
                  <c:v>1.5611368749713027E-2</c:v>
                </c:pt>
                <c:pt idx="21">
                  <c:v>1.6698883161512027E-2</c:v>
                </c:pt>
                <c:pt idx="22">
                  <c:v>7.4790586358197044E-3</c:v>
                </c:pt>
                <c:pt idx="24">
                  <c:v>6.2856020428206641E-3</c:v>
                </c:pt>
                <c:pt idx="25">
                  <c:v>8.310050863242352E-3</c:v>
                </c:pt>
                <c:pt idx="27">
                  <c:v>1.1092150170648464E-2</c:v>
                </c:pt>
                <c:pt idx="28">
                  <c:v>5.5019305019305019E-3</c:v>
                </c:pt>
                <c:pt idx="30">
                  <c:v>1.174284652545522E-2</c:v>
                </c:pt>
                <c:pt idx="31">
                  <c:v>1.7524339360222532E-2</c:v>
                </c:pt>
                <c:pt idx="33">
                  <c:v>1.9272025171624713E-2</c:v>
                </c:pt>
                <c:pt idx="34">
                  <c:v>5.5727317836558651E-3</c:v>
                </c:pt>
                <c:pt idx="36">
                  <c:v>2.7598787074765471E-2</c:v>
                </c:pt>
                <c:pt idx="37">
                  <c:v>1.7406579367614181E-2</c:v>
                </c:pt>
                <c:pt idx="39">
                  <c:v>9.0288482713058796E-3</c:v>
                </c:pt>
                <c:pt idx="40">
                  <c:v>1.1156116984759028E-2</c:v>
                </c:pt>
                <c:pt idx="42">
                  <c:v>8.7837269899974785E-3</c:v>
                </c:pt>
                <c:pt idx="43">
                  <c:v>2.081497335179823E-2</c:v>
                </c:pt>
                <c:pt idx="45">
                  <c:v>2.6077238296287098E-2</c:v>
                </c:pt>
                <c:pt idx="46">
                  <c:v>2.4487050117726204E-2</c:v>
                </c:pt>
                <c:pt idx="48">
                  <c:v>9.3496305755723791E-3</c:v>
                </c:pt>
                <c:pt idx="49">
                  <c:v>1.2623709287005546E-2</c:v>
                </c:pt>
                <c:pt idx="51">
                  <c:v>1.9761336515513126E-2</c:v>
                </c:pt>
                <c:pt idx="52">
                  <c:v>5.8346299177595021E-3</c:v>
                </c:pt>
              </c:numCache>
            </c:numRef>
          </c:val>
        </c:ser>
        <c:ser>
          <c:idx val="12"/>
          <c:order val="12"/>
          <c:tx>
            <c:strRef>
              <c:f>'saliva-7'!$A$13</c:f>
              <c:strCache>
                <c:ptCount val="1"/>
                <c:pt idx="0">
                  <c:v>Actinomyce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13:$BB$13</c:f>
              <c:numCache>
                <c:formatCode>0.0%</c:formatCode>
                <c:ptCount val="53"/>
                <c:pt idx="0">
                  <c:v>2.6253897062845266E-3</c:v>
                </c:pt>
                <c:pt idx="1">
                  <c:v>1.0403682040464091E-2</c:v>
                </c:pt>
                <c:pt idx="3">
                  <c:v>6.6901522252028056E-3</c:v>
                </c:pt>
                <c:pt idx="4">
                  <c:v>8.3126196976488331E-3</c:v>
                </c:pt>
                <c:pt idx="6">
                  <c:v>1.6493688639551193E-2</c:v>
                </c:pt>
                <c:pt idx="7">
                  <c:v>1.3042592215202771E-2</c:v>
                </c:pt>
                <c:pt idx="9">
                  <c:v>1.0638852672750977E-2</c:v>
                </c:pt>
                <c:pt idx="10">
                  <c:v>1.6628120264773904E-2</c:v>
                </c:pt>
                <c:pt idx="12">
                  <c:v>2.2492665435184179E-2</c:v>
                </c:pt>
                <c:pt idx="13">
                  <c:v>3.7119225337905994E-2</c:v>
                </c:pt>
                <c:pt idx="15">
                  <c:v>2.422957522525933E-3</c:v>
                </c:pt>
                <c:pt idx="16">
                  <c:v>1.9982659675488214E-2</c:v>
                </c:pt>
                <c:pt idx="18">
                  <c:v>6.4184852374839542E-3</c:v>
                </c:pt>
                <c:pt idx="19">
                  <c:v>1.5473621378392029E-2</c:v>
                </c:pt>
                <c:pt idx="21">
                  <c:v>3.9035652920962199E-2</c:v>
                </c:pt>
                <c:pt idx="22">
                  <c:v>2.6027124052652572E-2</c:v>
                </c:pt>
                <c:pt idx="24">
                  <c:v>7.267727362011393E-3</c:v>
                </c:pt>
                <c:pt idx="25">
                  <c:v>2.149151085321298E-3</c:v>
                </c:pt>
                <c:pt idx="27">
                  <c:v>1.5513496742165685E-3</c:v>
                </c:pt>
                <c:pt idx="28">
                  <c:v>6.2741312741312742E-4</c:v>
                </c:pt>
                <c:pt idx="30">
                  <c:v>7.5808249721293196E-3</c:v>
                </c:pt>
                <c:pt idx="31">
                  <c:v>1.8664812239221139E-2</c:v>
                </c:pt>
                <c:pt idx="33">
                  <c:v>2.3991704805491992E-2</c:v>
                </c:pt>
                <c:pt idx="34">
                  <c:v>1.0534753234856292E-2</c:v>
                </c:pt>
                <c:pt idx="36">
                  <c:v>5.069648441201554E-3</c:v>
                </c:pt>
                <c:pt idx="37">
                  <c:v>9.4857872884062597E-3</c:v>
                </c:pt>
                <c:pt idx="39">
                  <c:v>2.1990121747884357E-2</c:v>
                </c:pt>
                <c:pt idx="40">
                  <c:v>2.5024028559659482E-2</c:v>
                </c:pt>
                <c:pt idx="42">
                  <c:v>1.6264604522148441E-2</c:v>
                </c:pt>
                <c:pt idx="43">
                  <c:v>3.5838683956523565E-2</c:v>
                </c:pt>
                <c:pt idx="45">
                  <c:v>1.0555072643735255E-2</c:v>
                </c:pt>
                <c:pt idx="46">
                  <c:v>5.5062226707029933E-2</c:v>
                </c:pt>
                <c:pt idx="48">
                  <c:v>3.060293715223935E-2</c:v>
                </c:pt>
                <c:pt idx="49">
                  <c:v>3.670680515978797E-2</c:v>
                </c:pt>
                <c:pt idx="51">
                  <c:v>1.6515513126491646E-2</c:v>
                </c:pt>
                <c:pt idx="52">
                  <c:v>7.4460991331406975E-3</c:v>
                </c:pt>
              </c:numCache>
            </c:numRef>
          </c:val>
        </c:ser>
        <c:ser>
          <c:idx val="13"/>
          <c:order val="13"/>
          <c:tx>
            <c:strRef>
              <c:f>'saliva-7'!$A$14</c:f>
              <c:strCache>
                <c:ptCount val="1"/>
                <c:pt idx="0">
                  <c:v>Paraprevotella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14:$BB$14</c:f>
              <c:numCache>
                <c:formatCode>0.0%</c:formatCode>
                <c:ptCount val="53"/>
                <c:pt idx="0">
                  <c:v>1.8596510419515396E-3</c:v>
                </c:pt>
                <c:pt idx="1">
                  <c:v>3.8354588167609553E-2</c:v>
                </c:pt>
                <c:pt idx="3">
                  <c:v>7.1749458647102551E-3</c:v>
                </c:pt>
                <c:pt idx="4">
                  <c:v>1.7929179740026895E-3</c:v>
                </c:pt>
                <c:pt idx="6">
                  <c:v>3.4502103786816271E-2</c:v>
                </c:pt>
                <c:pt idx="7">
                  <c:v>1.0189525168127166E-3</c:v>
                </c:pt>
                <c:pt idx="9">
                  <c:v>6.779661016949153E-4</c:v>
                </c:pt>
                <c:pt idx="10">
                  <c:v>1.7146502910917935E-3</c:v>
                </c:pt>
                <c:pt idx="12">
                  <c:v>2.5535151581006195E-3</c:v>
                </c:pt>
                <c:pt idx="13">
                  <c:v>6.5563849102279609E-3</c:v>
                </c:pt>
                <c:pt idx="15">
                  <c:v>2.2715226773680625E-4</c:v>
                </c:pt>
                <c:pt idx="16">
                  <c:v>7.4315676479088397E-4</c:v>
                </c:pt>
                <c:pt idx="18">
                  <c:v>1.8338529249954154E-4</c:v>
                </c:pt>
                <c:pt idx="19">
                  <c:v>8.7240001836631613E-4</c:v>
                </c:pt>
                <c:pt idx="21">
                  <c:v>1.2618127147766323E-2</c:v>
                </c:pt>
                <c:pt idx="22">
                  <c:v>8.2269644994016761E-3</c:v>
                </c:pt>
                <c:pt idx="24">
                  <c:v>3.5749361618542523E-2</c:v>
                </c:pt>
                <c:pt idx="25">
                  <c:v>7.9876782004441576E-3</c:v>
                </c:pt>
                <c:pt idx="27">
                  <c:v>1.5513496742165683E-4</c:v>
                </c:pt>
                <c:pt idx="28">
                  <c:v>0</c:v>
                </c:pt>
                <c:pt idx="30">
                  <c:v>1.8580453363062059E-4</c:v>
                </c:pt>
                <c:pt idx="31">
                  <c:v>5.9248956884561891E-3</c:v>
                </c:pt>
                <c:pt idx="33">
                  <c:v>1.9307780320366133E-3</c:v>
                </c:pt>
                <c:pt idx="34">
                  <c:v>6.8704912401236686E-3</c:v>
                </c:pt>
                <c:pt idx="36">
                  <c:v>5.3491898038472471E-2</c:v>
                </c:pt>
                <c:pt idx="37">
                  <c:v>9.2622165442350687E-3</c:v>
                </c:pt>
                <c:pt idx="39">
                  <c:v>1.8498128165602291E-2</c:v>
                </c:pt>
                <c:pt idx="40">
                  <c:v>1.0297954139777564E-4</c:v>
                </c:pt>
                <c:pt idx="42">
                  <c:v>2.7906194839035052E-2</c:v>
                </c:pt>
                <c:pt idx="43">
                  <c:v>1.1750388182466742E-3</c:v>
                </c:pt>
                <c:pt idx="45">
                  <c:v>1.5211722339500808E-3</c:v>
                </c:pt>
                <c:pt idx="46">
                  <c:v>1.4799865455768584E-3</c:v>
                </c:pt>
                <c:pt idx="48">
                  <c:v>7.7989601386481804E-3</c:v>
                </c:pt>
                <c:pt idx="49">
                  <c:v>4.0751294543003337E-3</c:v>
                </c:pt>
                <c:pt idx="51">
                  <c:v>2.8639618138424821E-3</c:v>
                </c:pt>
                <c:pt idx="52">
                  <c:v>1.3586352522782841E-2</c:v>
                </c:pt>
              </c:numCache>
            </c:numRef>
          </c:val>
        </c:ser>
        <c:ser>
          <c:idx val="14"/>
          <c:order val="14"/>
          <c:tx>
            <c:strRef>
              <c:f>'saliva-7'!$A$15</c:f>
              <c:strCache>
                <c:ptCount val="1"/>
                <c:pt idx="0">
                  <c:v>Eubacterium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15:$BB$15</c:f>
              <c:numCache>
                <c:formatCode>0.0%</c:formatCode>
                <c:ptCount val="53"/>
                <c:pt idx="0">
                  <c:v>9.0794727342339877E-3</c:v>
                </c:pt>
                <c:pt idx="1">
                  <c:v>4.362834404065586E-3</c:v>
                </c:pt>
                <c:pt idx="3">
                  <c:v>6.787110953104295E-4</c:v>
                </c:pt>
                <c:pt idx="4">
                  <c:v>2.4448881463673038E-3</c:v>
                </c:pt>
                <c:pt idx="6">
                  <c:v>1.7952314165497897E-3</c:v>
                </c:pt>
                <c:pt idx="7">
                  <c:v>0</c:v>
                </c:pt>
                <c:pt idx="9">
                  <c:v>5.1629726205997392E-3</c:v>
                </c:pt>
                <c:pt idx="10">
                  <c:v>6.4598452827179199E-3</c:v>
                </c:pt>
                <c:pt idx="12">
                  <c:v>1.7059654460502009E-2</c:v>
                </c:pt>
                <c:pt idx="13">
                  <c:v>1.2557998789590479E-2</c:v>
                </c:pt>
                <c:pt idx="15">
                  <c:v>5.3002195805254785E-3</c:v>
                </c:pt>
                <c:pt idx="16">
                  <c:v>6.2755460137896863E-3</c:v>
                </c:pt>
                <c:pt idx="18">
                  <c:v>2.7568922305764409E-2</c:v>
                </c:pt>
                <c:pt idx="19">
                  <c:v>9.1372422976261532E-3</c:v>
                </c:pt>
                <c:pt idx="21">
                  <c:v>4.8324742268041239E-3</c:v>
                </c:pt>
                <c:pt idx="22">
                  <c:v>3.4403669724770644E-3</c:v>
                </c:pt>
                <c:pt idx="24">
                  <c:v>1.0410528383421725E-2</c:v>
                </c:pt>
                <c:pt idx="25">
                  <c:v>3.2595458127373019E-3</c:v>
                </c:pt>
                <c:pt idx="27">
                  <c:v>5.3521563760471607E-3</c:v>
                </c:pt>
                <c:pt idx="28">
                  <c:v>2.5096525096525097E-3</c:v>
                </c:pt>
                <c:pt idx="30">
                  <c:v>6.3173541434411004E-4</c:v>
                </c:pt>
                <c:pt idx="31">
                  <c:v>3.5326842837273991E-3</c:v>
                </c:pt>
                <c:pt idx="33">
                  <c:v>1.0655034324942792E-2</c:v>
                </c:pt>
                <c:pt idx="34">
                  <c:v>9.1224855910530932E-3</c:v>
                </c:pt>
                <c:pt idx="36">
                  <c:v>4.122050601724628E-3</c:v>
                </c:pt>
                <c:pt idx="37">
                  <c:v>1.8716065154902588E-2</c:v>
                </c:pt>
                <c:pt idx="39">
                  <c:v>9.2490640828011457E-3</c:v>
                </c:pt>
                <c:pt idx="40">
                  <c:v>4.3594672525058354E-3</c:v>
                </c:pt>
                <c:pt idx="42">
                  <c:v>1.5886357905354292E-2</c:v>
                </c:pt>
                <c:pt idx="43">
                  <c:v>1.0617315036300307E-2</c:v>
                </c:pt>
                <c:pt idx="45">
                  <c:v>6.8018129889482179E-2</c:v>
                </c:pt>
                <c:pt idx="46">
                  <c:v>3.2660612176252941E-2</c:v>
                </c:pt>
                <c:pt idx="48">
                  <c:v>3.5574204141202224E-3</c:v>
                </c:pt>
                <c:pt idx="49">
                  <c:v>2.4818457578821584E-3</c:v>
                </c:pt>
                <c:pt idx="51">
                  <c:v>1.035799522673031E-2</c:v>
                </c:pt>
                <c:pt idx="52">
                  <c:v>1.0280062236052456E-3</c:v>
                </c:pt>
              </c:numCache>
            </c:numRef>
          </c:val>
        </c:ser>
        <c:ser>
          <c:idx val="15"/>
          <c:order val="15"/>
          <c:tx>
            <c:strRef>
              <c:f>'saliva-7'!$A$16</c:f>
              <c:strCache>
                <c:ptCount val="1"/>
                <c:pt idx="0">
                  <c:v>Gemell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16:$BB$16</c:f>
              <c:numCache>
                <c:formatCode>0.0%</c:formatCode>
                <c:ptCount val="53"/>
                <c:pt idx="0">
                  <c:v>2.5488158398512279E-2</c:v>
                </c:pt>
                <c:pt idx="1">
                  <c:v>2.4307220251222554E-2</c:v>
                </c:pt>
                <c:pt idx="3">
                  <c:v>8.7262855111340937E-3</c:v>
                </c:pt>
                <c:pt idx="4">
                  <c:v>1.3895114298520844E-2</c:v>
                </c:pt>
                <c:pt idx="6">
                  <c:v>2.6367461430575035E-3</c:v>
                </c:pt>
                <c:pt idx="7">
                  <c:v>0.11785884111133754</c:v>
                </c:pt>
                <c:pt idx="9">
                  <c:v>2.0338983050847458E-3</c:v>
                </c:pt>
                <c:pt idx="10">
                  <c:v>1.8302894967700774E-2</c:v>
                </c:pt>
                <c:pt idx="12">
                  <c:v>1.7711615777463871E-2</c:v>
                </c:pt>
                <c:pt idx="13">
                  <c:v>3.1268912648779505E-2</c:v>
                </c:pt>
                <c:pt idx="15">
                  <c:v>2.1730900280154463E-2</c:v>
                </c:pt>
                <c:pt idx="16">
                  <c:v>5.2227405970026008E-2</c:v>
                </c:pt>
                <c:pt idx="18">
                  <c:v>1.8766428265786419E-2</c:v>
                </c:pt>
                <c:pt idx="19">
                  <c:v>1.9238716194499288E-2</c:v>
                </c:pt>
                <c:pt idx="21">
                  <c:v>5.1009450171821307E-3</c:v>
                </c:pt>
                <c:pt idx="22">
                  <c:v>3.4652971679297963E-2</c:v>
                </c:pt>
                <c:pt idx="24">
                  <c:v>1.7612780724153735E-2</c:v>
                </c:pt>
                <c:pt idx="25">
                  <c:v>1.6297729063686511E-2</c:v>
                </c:pt>
                <c:pt idx="27">
                  <c:v>0</c:v>
                </c:pt>
                <c:pt idx="28">
                  <c:v>9.6525096525096525E-5</c:v>
                </c:pt>
                <c:pt idx="30">
                  <c:v>1.2597547380156076E-2</c:v>
                </c:pt>
                <c:pt idx="31">
                  <c:v>6.8706536856745484E-3</c:v>
                </c:pt>
                <c:pt idx="33">
                  <c:v>1.2800343249427918E-2</c:v>
                </c:pt>
                <c:pt idx="34">
                  <c:v>2.6336883087140731E-2</c:v>
                </c:pt>
                <c:pt idx="36">
                  <c:v>3.1270728702738559E-3</c:v>
                </c:pt>
                <c:pt idx="37">
                  <c:v>2.2580645161290321E-2</c:v>
                </c:pt>
                <c:pt idx="39">
                  <c:v>7.4244187875546607E-3</c:v>
                </c:pt>
                <c:pt idx="40">
                  <c:v>3.0481944253741591E-2</c:v>
                </c:pt>
                <c:pt idx="42">
                  <c:v>2.2988988820711105E-2</c:v>
                </c:pt>
                <c:pt idx="43">
                  <c:v>8.3595618783834827E-2</c:v>
                </c:pt>
                <c:pt idx="45">
                  <c:v>6.0226002731901158E-3</c:v>
                </c:pt>
                <c:pt idx="46">
                  <c:v>7.265388496468214E-3</c:v>
                </c:pt>
                <c:pt idx="48">
                  <c:v>1.6418863449785643E-3</c:v>
                </c:pt>
                <c:pt idx="49">
                  <c:v>3.002726966326562E-3</c:v>
                </c:pt>
                <c:pt idx="51">
                  <c:v>3.7326968973747016E-2</c:v>
                </c:pt>
                <c:pt idx="52">
                  <c:v>1.9865525672371639E-2</c:v>
                </c:pt>
              </c:numCache>
            </c:numRef>
          </c:val>
        </c:ser>
        <c:ser>
          <c:idx val="16"/>
          <c:order val="16"/>
          <c:tx>
            <c:strRef>
              <c:f>'saliva-7'!$A$17</c:f>
              <c:strCache>
                <c:ptCount val="1"/>
                <c:pt idx="0">
                  <c:v>Capnocytophaga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17:$BB$17</c:f>
              <c:numCache>
                <c:formatCode>0.0%</c:formatCode>
                <c:ptCount val="53"/>
                <c:pt idx="0">
                  <c:v>1.2962861674779851E-2</c:v>
                </c:pt>
                <c:pt idx="1">
                  <c:v>1.0307795570045067E-2</c:v>
                </c:pt>
                <c:pt idx="3">
                  <c:v>2.058756989108303E-2</c:v>
                </c:pt>
                <c:pt idx="4">
                  <c:v>2.4082148241717942E-2</c:v>
                </c:pt>
                <c:pt idx="6">
                  <c:v>8.9761570827489483E-4</c:v>
                </c:pt>
                <c:pt idx="7">
                  <c:v>3.1927178860131785E-3</c:v>
                </c:pt>
                <c:pt idx="9">
                  <c:v>5.3715775749674051E-3</c:v>
                </c:pt>
                <c:pt idx="10">
                  <c:v>4.4261902863067231E-3</c:v>
                </c:pt>
                <c:pt idx="12">
                  <c:v>7.2259045963272844E-3</c:v>
                </c:pt>
                <c:pt idx="13">
                  <c:v>7.0607222110147271E-4</c:v>
                </c:pt>
                <c:pt idx="15">
                  <c:v>1.2417657302945407E-2</c:v>
                </c:pt>
                <c:pt idx="16">
                  <c:v>1.0280335246273895E-2</c:v>
                </c:pt>
                <c:pt idx="18">
                  <c:v>7.2742832691484807E-3</c:v>
                </c:pt>
                <c:pt idx="19">
                  <c:v>1.2029937095367097E-2</c:v>
                </c:pt>
                <c:pt idx="21">
                  <c:v>7.8393470790378006E-3</c:v>
                </c:pt>
                <c:pt idx="22">
                  <c:v>6.132828081372158E-3</c:v>
                </c:pt>
                <c:pt idx="24">
                  <c:v>7.3986774045701562E-3</c:v>
                </c:pt>
                <c:pt idx="25">
                  <c:v>4.6815674475248946E-2</c:v>
                </c:pt>
                <c:pt idx="27">
                  <c:v>2.3270245113248526E-4</c:v>
                </c:pt>
                <c:pt idx="28">
                  <c:v>4.8262548262548262E-5</c:v>
                </c:pt>
                <c:pt idx="30">
                  <c:v>5.1616499442586401E-2</c:v>
                </c:pt>
                <c:pt idx="31">
                  <c:v>2.4394993045897078E-2</c:v>
                </c:pt>
                <c:pt idx="33">
                  <c:v>9.1533180778032037E-3</c:v>
                </c:pt>
                <c:pt idx="34">
                  <c:v>1.9084697889232413E-3</c:v>
                </c:pt>
                <c:pt idx="36">
                  <c:v>4.6669193594238607E-3</c:v>
                </c:pt>
                <c:pt idx="37">
                  <c:v>9.1983391887575858E-3</c:v>
                </c:pt>
                <c:pt idx="39">
                  <c:v>3.1144807625758959E-3</c:v>
                </c:pt>
                <c:pt idx="40">
                  <c:v>7.2085678978442954E-3</c:v>
                </c:pt>
                <c:pt idx="42">
                  <c:v>3.152055139951248E-3</c:v>
                </c:pt>
                <c:pt idx="43">
                  <c:v>2.0143522598514416E-3</c:v>
                </c:pt>
                <c:pt idx="45">
                  <c:v>2.4835465044082952E-3</c:v>
                </c:pt>
                <c:pt idx="46">
                  <c:v>1.7154389505549949E-3</c:v>
                </c:pt>
                <c:pt idx="48">
                  <c:v>1.3591170300100338E-2</c:v>
                </c:pt>
                <c:pt idx="49">
                  <c:v>1.7158439807580354E-2</c:v>
                </c:pt>
                <c:pt idx="51">
                  <c:v>3.7231503579952269E-3</c:v>
                </c:pt>
                <c:pt idx="52">
                  <c:v>4.6954878861969326E-3</c:v>
                </c:pt>
              </c:numCache>
            </c:numRef>
          </c:val>
        </c:ser>
        <c:ser>
          <c:idx val="17"/>
          <c:order val="17"/>
          <c:tx>
            <c:strRef>
              <c:f>'saliva-7'!$A$18</c:f>
              <c:strCache>
                <c:ptCount val="1"/>
                <c:pt idx="0">
                  <c:v>Oribacterium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18:$BB$18</c:f>
              <c:numCache>
                <c:formatCode>0.0%</c:formatCode>
                <c:ptCount val="53"/>
                <c:pt idx="0">
                  <c:v>1.0939123776185527E-4</c:v>
                </c:pt>
                <c:pt idx="1">
                  <c:v>2.3012752900565731E-3</c:v>
                </c:pt>
                <c:pt idx="3">
                  <c:v>7.6920590801848676E-3</c:v>
                </c:pt>
                <c:pt idx="4">
                  <c:v>1.3895114298520844E-2</c:v>
                </c:pt>
                <c:pt idx="6">
                  <c:v>1.6044880785413745E-2</c:v>
                </c:pt>
                <c:pt idx="7">
                  <c:v>1.4333265403165546E-2</c:v>
                </c:pt>
                <c:pt idx="9">
                  <c:v>1.9817470664928293E-3</c:v>
                </c:pt>
                <c:pt idx="10">
                  <c:v>5.9414626365738897E-3</c:v>
                </c:pt>
                <c:pt idx="12">
                  <c:v>2.8794958165815495E-3</c:v>
                </c:pt>
                <c:pt idx="13">
                  <c:v>5.446842848497075E-3</c:v>
                </c:pt>
                <c:pt idx="15">
                  <c:v>1.3553418641629438E-2</c:v>
                </c:pt>
                <c:pt idx="16">
                  <c:v>3.4680649023574586E-3</c:v>
                </c:pt>
                <c:pt idx="18">
                  <c:v>1.0391833241640688E-3</c:v>
                </c:pt>
                <c:pt idx="19">
                  <c:v>4.0865053491895859E-3</c:v>
                </c:pt>
                <c:pt idx="21">
                  <c:v>3.8122852233676975E-3</c:v>
                </c:pt>
                <c:pt idx="22">
                  <c:v>1.326286398085361E-2</c:v>
                </c:pt>
                <c:pt idx="24">
                  <c:v>6.0237019577031366E-3</c:v>
                </c:pt>
                <c:pt idx="25">
                  <c:v>1.7551400530123934E-3</c:v>
                </c:pt>
                <c:pt idx="27">
                  <c:v>3.8783741855414212E-4</c:v>
                </c:pt>
                <c:pt idx="28">
                  <c:v>3.3783783783783786E-4</c:v>
                </c:pt>
                <c:pt idx="30">
                  <c:v>4.8680787811222594E-3</c:v>
                </c:pt>
                <c:pt idx="31">
                  <c:v>1.0152990264255911E-2</c:v>
                </c:pt>
                <c:pt idx="33">
                  <c:v>3.5040045766590389E-3</c:v>
                </c:pt>
                <c:pt idx="34">
                  <c:v>3.2062292453910453E-3</c:v>
                </c:pt>
                <c:pt idx="36">
                  <c:v>5.164408225149247E-3</c:v>
                </c:pt>
                <c:pt idx="37">
                  <c:v>2.7786649632705204E-2</c:v>
                </c:pt>
                <c:pt idx="39">
                  <c:v>5.6941516972347185E-3</c:v>
                </c:pt>
                <c:pt idx="40">
                  <c:v>2.3342029383495812E-2</c:v>
                </c:pt>
                <c:pt idx="42">
                  <c:v>9.2460284105236618E-3</c:v>
                </c:pt>
                <c:pt idx="43">
                  <c:v>5.4177682655587728E-2</c:v>
                </c:pt>
                <c:pt idx="45">
                  <c:v>3.19756612442568E-3</c:v>
                </c:pt>
                <c:pt idx="46">
                  <c:v>3.6091490077362932E-2</c:v>
                </c:pt>
                <c:pt idx="48">
                  <c:v>7.8445680926753619E-3</c:v>
                </c:pt>
                <c:pt idx="49">
                  <c:v>9.6209823206789835E-3</c:v>
                </c:pt>
                <c:pt idx="51">
                  <c:v>9.4797136038186153E-2</c:v>
                </c:pt>
                <c:pt idx="52">
                  <c:v>3.4174260946877085E-3</c:v>
                </c:pt>
              </c:numCache>
            </c:numRef>
          </c:val>
        </c:ser>
        <c:ser>
          <c:idx val="18"/>
          <c:order val="18"/>
          <c:tx>
            <c:strRef>
              <c:f>'saliva-7'!$A$19</c:f>
              <c:strCache>
                <c:ptCount val="1"/>
                <c:pt idx="0">
                  <c:v>Aggregatibacter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19:$BB$19</c:f>
              <c:numCache>
                <c:formatCode>0.0%</c:formatCode>
                <c:ptCount val="53"/>
                <c:pt idx="0">
                  <c:v>6.8533610457802333E-2</c:v>
                </c:pt>
                <c:pt idx="1">
                  <c:v>5.4655288138843608E-3</c:v>
                </c:pt>
                <c:pt idx="3">
                  <c:v>6.4639151934326627E-5</c:v>
                </c:pt>
                <c:pt idx="4">
                  <c:v>1.2224440731836518E-4</c:v>
                </c:pt>
                <c:pt idx="6">
                  <c:v>5.6100981767180927E-5</c:v>
                </c:pt>
                <c:pt idx="7">
                  <c:v>6.7930167787514441E-5</c:v>
                </c:pt>
                <c:pt idx="9">
                  <c:v>1.3820078226857888E-2</c:v>
                </c:pt>
                <c:pt idx="10">
                  <c:v>1.9499162612648537E-2</c:v>
                </c:pt>
                <c:pt idx="12">
                  <c:v>9.2361186569596876E-4</c:v>
                </c:pt>
                <c:pt idx="13">
                  <c:v>9.0780714141617917E-4</c:v>
                </c:pt>
                <c:pt idx="15">
                  <c:v>3.0286969031574165E-3</c:v>
                </c:pt>
                <c:pt idx="16">
                  <c:v>5.7388216836629369E-3</c:v>
                </c:pt>
                <c:pt idx="18">
                  <c:v>1.1125374411638854E-2</c:v>
                </c:pt>
                <c:pt idx="19">
                  <c:v>1.1111621286560448E-2</c:v>
                </c:pt>
                <c:pt idx="21">
                  <c:v>3.9196735395189003E-3</c:v>
                </c:pt>
                <c:pt idx="22">
                  <c:v>4.4375747905863582E-3</c:v>
                </c:pt>
                <c:pt idx="24">
                  <c:v>1.198192889412689E-2</c:v>
                </c:pt>
                <c:pt idx="25">
                  <c:v>9.9577333619886819E-3</c:v>
                </c:pt>
                <c:pt idx="27">
                  <c:v>7.7567483710828415E-5</c:v>
                </c:pt>
                <c:pt idx="28">
                  <c:v>4.8262548262548262E-5</c:v>
                </c:pt>
                <c:pt idx="30">
                  <c:v>7.8781122259383128E-3</c:v>
                </c:pt>
                <c:pt idx="31">
                  <c:v>2.086230876216968E-3</c:v>
                </c:pt>
                <c:pt idx="33">
                  <c:v>6.3286613272311209E-3</c:v>
                </c:pt>
                <c:pt idx="34">
                  <c:v>1.4542539791595099E-2</c:v>
                </c:pt>
                <c:pt idx="36">
                  <c:v>8.5283805552923333E-3</c:v>
                </c:pt>
                <c:pt idx="37">
                  <c:v>4.5991695943787929E-3</c:v>
                </c:pt>
                <c:pt idx="39">
                  <c:v>2.3374335420140308E-2</c:v>
                </c:pt>
                <c:pt idx="40">
                  <c:v>1.0641219277770151E-3</c:v>
                </c:pt>
                <c:pt idx="42">
                  <c:v>3.7824661679414977E-4</c:v>
                </c:pt>
                <c:pt idx="43">
                  <c:v>4.1965672080238368E-5</c:v>
                </c:pt>
                <c:pt idx="45">
                  <c:v>7.8852601514963361E-3</c:v>
                </c:pt>
                <c:pt idx="46">
                  <c:v>5.9872182980154724E-3</c:v>
                </c:pt>
                <c:pt idx="48">
                  <c:v>4.560795402718234E-5</c:v>
                </c:pt>
                <c:pt idx="49">
                  <c:v>4.9024113735943869E-4</c:v>
                </c:pt>
                <c:pt idx="51">
                  <c:v>1.1933174224343676E-3</c:v>
                </c:pt>
                <c:pt idx="52">
                  <c:v>1.8754167592798399E-2</c:v>
                </c:pt>
              </c:numCache>
            </c:numRef>
          </c:val>
        </c:ser>
        <c:ser>
          <c:idx val="19"/>
          <c:order val="19"/>
          <c:tx>
            <c:strRef>
              <c:f>'saliva-7'!$A$20</c:f>
              <c:strCache>
                <c:ptCount val="1"/>
                <c:pt idx="0">
                  <c:v>Filifactor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20:$BB$20</c:f>
              <c:numCache>
                <c:formatCode>0.0%</c:formatCode>
                <c:ptCount val="53"/>
                <c:pt idx="0">
                  <c:v>3.0629546573319477E-3</c:v>
                </c:pt>
                <c:pt idx="1">
                  <c:v>3.1642535238277877E-3</c:v>
                </c:pt>
                <c:pt idx="3">
                  <c:v>6.787110953104295E-4</c:v>
                </c:pt>
                <c:pt idx="4">
                  <c:v>2.4448881463673038E-3</c:v>
                </c:pt>
                <c:pt idx="6">
                  <c:v>5.0490883590462838E-4</c:v>
                </c:pt>
                <c:pt idx="7">
                  <c:v>0</c:v>
                </c:pt>
                <c:pt idx="9">
                  <c:v>0</c:v>
                </c:pt>
                <c:pt idx="10">
                  <c:v>7.975117632985087E-5</c:v>
                </c:pt>
                <c:pt idx="12">
                  <c:v>0</c:v>
                </c:pt>
                <c:pt idx="13">
                  <c:v>5.0433730078676621E-5</c:v>
                </c:pt>
                <c:pt idx="15">
                  <c:v>4.6944801998939955E-3</c:v>
                </c:pt>
                <c:pt idx="16">
                  <c:v>7.7205730564386277E-3</c:v>
                </c:pt>
                <c:pt idx="18">
                  <c:v>2.7202151720765327E-2</c:v>
                </c:pt>
                <c:pt idx="19">
                  <c:v>7.0251159373708617E-3</c:v>
                </c:pt>
                <c:pt idx="21">
                  <c:v>3.2753436426116839E-3</c:v>
                </c:pt>
                <c:pt idx="22">
                  <c:v>1.0969285999202234E-3</c:v>
                </c:pt>
                <c:pt idx="24">
                  <c:v>5.8927519151443725E-3</c:v>
                </c:pt>
                <c:pt idx="25">
                  <c:v>8.9189770040833862E-3</c:v>
                </c:pt>
                <c:pt idx="27">
                  <c:v>1.5513496742165683E-4</c:v>
                </c:pt>
                <c:pt idx="28">
                  <c:v>0</c:v>
                </c:pt>
                <c:pt idx="30">
                  <c:v>1.0033444816053511E-3</c:v>
                </c:pt>
                <c:pt idx="31">
                  <c:v>1.3073713490959666E-3</c:v>
                </c:pt>
                <c:pt idx="33">
                  <c:v>8.7600114416475968E-3</c:v>
                </c:pt>
                <c:pt idx="34">
                  <c:v>2.1374861635940303E-3</c:v>
                </c:pt>
                <c:pt idx="36">
                  <c:v>3.9088410878423199E-3</c:v>
                </c:pt>
                <c:pt idx="37">
                  <c:v>9.741296710316193E-3</c:v>
                </c:pt>
                <c:pt idx="39">
                  <c:v>9.6580363041494956E-3</c:v>
                </c:pt>
                <c:pt idx="40">
                  <c:v>1.6133461485651518E-3</c:v>
                </c:pt>
                <c:pt idx="42">
                  <c:v>2.189627637219467E-2</c:v>
                </c:pt>
                <c:pt idx="43">
                  <c:v>2.6858030131352555E-3</c:v>
                </c:pt>
                <c:pt idx="45">
                  <c:v>3.5576803675648826E-2</c:v>
                </c:pt>
                <c:pt idx="46">
                  <c:v>2.9263370332996974E-3</c:v>
                </c:pt>
                <c:pt idx="48">
                  <c:v>1.1858068047067409E-3</c:v>
                </c:pt>
                <c:pt idx="49">
                  <c:v>7.6600177712412296E-4</c:v>
                </c:pt>
                <c:pt idx="51">
                  <c:v>4.7732696897374704E-5</c:v>
                </c:pt>
                <c:pt idx="52">
                  <c:v>0</c:v>
                </c:pt>
              </c:numCache>
            </c:numRef>
          </c:val>
        </c:ser>
        <c:ser>
          <c:idx val="20"/>
          <c:order val="20"/>
          <c:tx>
            <c:strRef>
              <c:f>'saliva-7'!$A$21</c:f>
              <c:strCache>
                <c:ptCount val="1"/>
                <c:pt idx="0">
                  <c:v>Selenomonas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21:$BB$21</c:f>
              <c:numCache>
                <c:formatCode>0.0%</c:formatCode>
                <c:ptCount val="53"/>
                <c:pt idx="0">
                  <c:v>4.3209538915932834E-3</c:v>
                </c:pt>
                <c:pt idx="1">
                  <c:v>1.7259564675424297E-3</c:v>
                </c:pt>
                <c:pt idx="3">
                  <c:v>9.6958727901489935E-4</c:v>
                </c:pt>
                <c:pt idx="4">
                  <c:v>1.1816959374108635E-3</c:v>
                </c:pt>
                <c:pt idx="6">
                  <c:v>5.7784011220196356E-3</c:v>
                </c:pt>
                <c:pt idx="7">
                  <c:v>0</c:v>
                </c:pt>
                <c:pt idx="9">
                  <c:v>1.1838331160365059E-2</c:v>
                </c:pt>
                <c:pt idx="10">
                  <c:v>1.4355211739373157E-3</c:v>
                </c:pt>
                <c:pt idx="12">
                  <c:v>1.6842334021514723E-3</c:v>
                </c:pt>
                <c:pt idx="13">
                  <c:v>4.5390357070808959E-4</c:v>
                </c:pt>
                <c:pt idx="15">
                  <c:v>2.1352313167259787E-2</c:v>
                </c:pt>
                <c:pt idx="16">
                  <c:v>2.5143470542091574E-2</c:v>
                </c:pt>
                <c:pt idx="18">
                  <c:v>1.430405281496424E-2</c:v>
                </c:pt>
                <c:pt idx="19">
                  <c:v>3.627347444786262E-3</c:v>
                </c:pt>
                <c:pt idx="21">
                  <c:v>3.1035223367697595E-2</c:v>
                </c:pt>
                <c:pt idx="22">
                  <c:v>4.9860390905464701E-4</c:v>
                </c:pt>
                <c:pt idx="24">
                  <c:v>1.6368755319845479E-3</c:v>
                </c:pt>
                <c:pt idx="25">
                  <c:v>6.4832724407192493E-3</c:v>
                </c:pt>
                <c:pt idx="27">
                  <c:v>0</c:v>
                </c:pt>
                <c:pt idx="28">
                  <c:v>0</c:v>
                </c:pt>
                <c:pt idx="30">
                  <c:v>1.3823857302118171E-2</c:v>
                </c:pt>
                <c:pt idx="31">
                  <c:v>4.0166898470097356E-2</c:v>
                </c:pt>
                <c:pt idx="33">
                  <c:v>8.0449084668192221E-3</c:v>
                </c:pt>
                <c:pt idx="34">
                  <c:v>2.8627046833848619E-3</c:v>
                </c:pt>
                <c:pt idx="36">
                  <c:v>6.0646261726523265E-3</c:v>
                </c:pt>
                <c:pt idx="37">
                  <c:v>1.7885659533695304E-3</c:v>
                </c:pt>
                <c:pt idx="39">
                  <c:v>3.5549123855664264E-3</c:v>
                </c:pt>
                <c:pt idx="40">
                  <c:v>1.5790196347658931E-3</c:v>
                </c:pt>
                <c:pt idx="42">
                  <c:v>2.7738085231570984E-3</c:v>
                </c:pt>
                <c:pt idx="43">
                  <c:v>1.0491418020059592E-3</c:v>
                </c:pt>
                <c:pt idx="45">
                  <c:v>1.4311436731652799E-2</c:v>
                </c:pt>
                <c:pt idx="46">
                  <c:v>4.0699630003363605E-3</c:v>
                </c:pt>
                <c:pt idx="48">
                  <c:v>1.5050624828970172E-3</c:v>
                </c:pt>
                <c:pt idx="49">
                  <c:v>2.3899255446272636E-3</c:v>
                </c:pt>
                <c:pt idx="51">
                  <c:v>1.9093078758949881E-3</c:v>
                </c:pt>
                <c:pt idx="52">
                  <c:v>2.0837963991998222E-3</c:v>
                </c:pt>
              </c:numCache>
            </c:numRef>
          </c:val>
        </c:ser>
        <c:ser>
          <c:idx val="21"/>
          <c:order val="21"/>
          <c:tx>
            <c:strRef>
              <c:f>'saliva-7'!$A$22</c:f>
              <c:strCache>
                <c:ptCount val="1"/>
                <c:pt idx="0">
                  <c:v>Granulicatella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22:$BB$22</c:f>
              <c:numCache>
                <c:formatCode>0.0%</c:formatCode>
                <c:ptCount val="53"/>
                <c:pt idx="0">
                  <c:v>1.2142427391565935E-2</c:v>
                </c:pt>
                <c:pt idx="1">
                  <c:v>1.6732189088119666E-2</c:v>
                </c:pt>
                <c:pt idx="3">
                  <c:v>4.2015448757312304E-3</c:v>
                </c:pt>
                <c:pt idx="4">
                  <c:v>4.6860356138706651E-3</c:v>
                </c:pt>
                <c:pt idx="6">
                  <c:v>9.4249649368863958E-3</c:v>
                </c:pt>
                <c:pt idx="7">
                  <c:v>6.4465729230351196E-2</c:v>
                </c:pt>
                <c:pt idx="9">
                  <c:v>2.9204693611473271E-3</c:v>
                </c:pt>
                <c:pt idx="10">
                  <c:v>1.2879814977270915E-2</c:v>
                </c:pt>
                <c:pt idx="12">
                  <c:v>2.2927306313158754E-2</c:v>
                </c:pt>
                <c:pt idx="13">
                  <c:v>1.2860601170062538E-2</c:v>
                </c:pt>
                <c:pt idx="15">
                  <c:v>6.8145680321041874E-3</c:v>
                </c:pt>
                <c:pt idx="16">
                  <c:v>7.55542710870732E-3</c:v>
                </c:pt>
                <c:pt idx="18">
                  <c:v>1.6137905739959654E-2</c:v>
                </c:pt>
                <c:pt idx="19">
                  <c:v>1.6437852977639011E-2</c:v>
                </c:pt>
                <c:pt idx="21">
                  <c:v>1.9866838487972507E-3</c:v>
                </c:pt>
                <c:pt idx="22">
                  <c:v>1.4808536098923016E-2</c:v>
                </c:pt>
                <c:pt idx="24">
                  <c:v>7.595102468408302E-3</c:v>
                </c:pt>
                <c:pt idx="25">
                  <c:v>7.7727630919120277E-3</c:v>
                </c:pt>
                <c:pt idx="27">
                  <c:v>0</c:v>
                </c:pt>
                <c:pt idx="28">
                  <c:v>0</c:v>
                </c:pt>
                <c:pt idx="30">
                  <c:v>1.6685247120029729E-2</c:v>
                </c:pt>
                <c:pt idx="31">
                  <c:v>2.2531293463143253E-3</c:v>
                </c:pt>
                <c:pt idx="33">
                  <c:v>7.3655606407322652E-3</c:v>
                </c:pt>
                <c:pt idx="34">
                  <c:v>9.5041795488377424E-3</c:v>
                </c:pt>
                <c:pt idx="36">
                  <c:v>2.9612432483653939E-3</c:v>
                </c:pt>
                <c:pt idx="37">
                  <c:v>6.9945704247844137E-3</c:v>
                </c:pt>
                <c:pt idx="39">
                  <c:v>5.8514487054456225E-3</c:v>
                </c:pt>
                <c:pt idx="40">
                  <c:v>3.7381573527392561E-2</c:v>
                </c:pt>
                <c:pt idx="42">
                  <c:v>1.0506850466504162E-3</c:v>
                </c:pt>
                <c:pt idx="43">
                  <c:v>3.000545553737043E-2</c:v>
                </c:pt>
                <c:pt idx="45">
                  <c:v>3.0423444679001615E-3</c:v>
                </c:pt>
                <c:pt idx="46">
                  <c:v>2.5697948200470905E-2</c:v>
                </c:pt>
                <c:pt idx="48">
                  <c:v>3.1925567819027639E-3</c:v>
                </c:pt>
                <c:pt idx="49">
                  <c:v>3.2784876060912463E-3</c:v>
                </c:pt>
                <c:pt idx="51">
                  <c:v>1.5083532219570405E-2</c:v>
                </c:pt>
                <c:pt idx="52">
                  <c:v>7.5572349410980219E-3</c:v>
                </c:pt>
              </c:numCache>
            </c:numRef>
          </c:val>
        </c:ser>
        <c:ser>
          <c:idx val="22"/>
          <c:order val="22"/>
          <c:tx>
            <c:strRef>
              <c:f>'saliva-7'!$A$23</c:f>
              <c:strCache>
                <c:ptCount val="1"/>
                <c:pt idx="0">
                  <c:v>Haemophilus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23:$BB$23</c:f>
              <c:numCache>
                <c:formatCode>0.0%</c:formatCode>
                <c:ptCount val="53"/>
                <c:pt idx="0">
                  <c:v>7.4550128534704371E-2</c:v>
                </c:pt>
                <c:pt idx="1">
                  <c:v>1.6780132323329178E-3</c:v>
                </c:pt>
                <c:pt idx="3">
                  <c:v>2.3270094696357583E-3</c:v>
                </c:pt>
                <c:pt idx="4">
                  <c:v>2.4448881463673037E-4</c:v>
                </c:pt>
                <c:pt idx="6">
                  <c:v>0</c:v>
                </c:pt>
                <c:pt idx="7">
                  <c:v>0</c:v>
                </c:pt>
                <c:pt idx="9">
                  <c:v>9.9087353324641466E-4</c:v>
                </c:pt>
                <c:pt idx="10">
                  <c:v>2.6716644070500042E-3</c:v>
                </c:pt>
                <c:pt idx="12">
                  <c:v>1.6299032924046506E-4</c:v>
                </c:pt>
                <c:pt idx="13">
                  <c:v>0</c:v>
                </c:pt>
                <c:pt idx="15">
                  <c:v>3.483001438631029E-3</c:v>
                </c:pt>
                <c:pt idx="16">
                  <c:v>4.7479459972750914E-3</c:v>
                </c:pt>
                <c:pt idx="18">
                  <c:v>5.5015587749862463E-3</c:v>
                </c:pt>
                <c:pt idx="19">
                  <c:v>1.3315579227696406E-3</c:v>
                </c:pt>
                <c:pt idx="21">
                  <c:v>1.8792955326460482E-3</c:v>
                </c:pt>
                <c:pt idx="22">
                  <c:v>2.3932987634623054E-3</c:v>
                </c:pt>
                <c:pt idx="24">
                  <c:v>5.2380017023505535E-3</c:v>
                </c:pt>
                <c:pt idx="25">
                  <c:v>1.3611290207034888E-3</c:v>
                </c:pt>
                <c:pt idx="27">
                  <c:v>0</c:v>
                </c:pt>
                <c:pt idx="28">
                  <c:v>0</c:v>
                </c:pt>
                <c:pt idx="30">
                  <c:v>4.6079524340393906E-3</c:v>
                </c:pt>
                <c:pt idx="31">
                  <c:v>2.0027816411682894E-3</c:v>
                </c:pt>
                <c:pt idx="33">
                  <c:v>4.4693935926773459E-3</c:v>
                </c:pt>
                <c:pt idx="34">
                  <c:v>6.7941524485667388E-3</c:v>
                </c:pt>
                <c:pt idx="36">
                  <c:v>4.1694304936984745E-3</c:v>
                </c:pt>
                <c:pt idx="37">
                  <c:v>8.6234429894602367E-4</c:v>
                </c:pt>
                <c:pt idx="39">
                  <c:v>8.9344700663793377E-3</c:v>
                </c:pt>
                <c:pt idx="40">
                  <c:v>3.432651379925855E-4</c:v>
                </c:pt>
                <c:pt idx="42">
                  <c:v>2.1013700933008323E-4</c:v>
                </c:pt>
                <c:pt idx="43">
                  <c:v>0</c:v>
                </c:pt>
                <c:pt idx="45">
                  <c:v>1.8626598783062212E-4</c:v>
                </c:pt>
                <c:pt idx="46">
                  <c:v>4.3726875210225362E-4</c:v>
                </c:pt>
                <c:pt idx="48">
                  <c:v>4.560795402718234E-5</c:v>
                </c:pt>
                <c:pt idx="49">
                  <c:v>6.740815638692282E-4</c:v>
                </c:pt>
                <c:pt idx="51">
                  <c:v>9.5465393794749406E-4</c:v>
                </c:pt>
                <c:pt idx="52">
                  <c:v>4.6399199822182704E-3</c:v>
                </c:pt>
              </c:numCache>
            </c:numRef>
          </c:val>
        </c:ser>
        <c:ser>
          <c:idx val="23"/>
          <c:order val="23"/>
          <c:tx>
            <c:strRef>
              <c:f>'saliva-7'!$A$24</c:f>
              <c:strCache>
                <c:ptCount val="1"/>
                <c:pt idx="0">
                  <c:v>Syntrophococcus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24:$BB$24</c:f>
              <c:numCache>
                <c:formatCode>0.0%</c:formatCode>
                <c:ptCount val="53"/>
                <c:pt idx="0">
                  <c:v>2.8441721818082371E-3</c:v>
                </c:pt>
                <c:pt idx="1">
                  <c:v>5.8970179307699681E-3</c:v>
                </c:pt>
                <c:pt idx="3">
                  <c:v>6.9810284089072755E-3</c:v>
                </c:pt>
                <c:pt idx="4">
                  <c:v>1.092050038710729E-2</c:v>
                </c:pt>
                <c:pt idx="6">
                  <c:v>7.6858345021037864E-3</c:v>
                </c:pt>
                <c:pt idx="7">
                  <c:v>1.3450173221927857E-2</c:v>
                </c:pt>
                <c:pt idx="9">
                  <c:v>1.3037809647979139E-3</c:v>
                </c:pt>
                <c:pt idx="10">
                  <c:v>9.3707632187574764E-3</c:v>
                </c:pt>
                <c:pt idx="12">
                  <c:v>6.7912637183527112E-3</c:v>
                </c:pt>
                <c:pt idx="13">
                  <c:v>9.431107524712528E-3</c:v>
                </c:pt>
                <c:pt idx="15">
                  <c:v>1.8929355644733852E-3</c:v>
                </c:pt>
                <c:pt idx="16">
                  <c:v>3.2616324676933242E-3</c:v>
                </c:pt>
                <c:pt idx="18">
                  <c:v>3.3620636958249283E-3</c:v>
                </c:pt>
                <c:pt idx="19">
                  <c:v>2.8008632168602782E-3</c:v>
                </c:pt>
                <c:pt idx="21">
                  <c:v>1.1544243986254296E-2</c:v>
                </c:pt>
                <c:pt idx="22">
                  <c:v>1.9046669325887514E-2</c:v>
                </c:pt>
                <c:pt idx="24">
                  <c:v>5.0415766385124077E-3</c:v>
                </c:pt>
                <c:pt idx="25">
                  <c:v>7.5578479833798987E-3</c:v>
                </c:pt>
                <c:pt idx="27">
                  <c:v>0</c:v>
                </c:pt>
                <c:pt idx="28">
                  <c:v>0</c:v>
                </c:pt>
                <c:pt idx="30">
                  <c:v>3.2329988851727983E-3</c:v>
                </c:pt>
                <c:pt idx="31">
                  <c:v>4.2837273991655073E-3</c:v>
                </c:pt>
                <c:pt idx="33">
                  <c:v>9.4751144164759733E-3</c:v>
                </c:pt>
                <c:pt idx="34">
                  <c:v>6.2979503034466967E-3</c:v>
                </c:pt>
                <c:pt idx="36">
                  <c:v>7.6281626077892547E-3</c:v>
                </c:pt>
                <c:pt idx="37">
                  <c:v>1.3062919195145321E-2</c:v>
                </c:pt>
                <c:pt idx="39">
                  <c:v>6.291880328436153E-3</c:v>
                </c:pt>
                <c:pt idx="40">
                  <c:v>4.0162021145132504E-3</c:v>
                </c:pt>
                <c:pt idx="42">
                  <c:v>5.7157266537782633E-3</c:v>
                </c:pt>
                <c:pt idx="43">
                  <c:v>7.3439926140417139E-3</c:v>
                </c:pt>
                <c:pt idx="45">
                  <c:v>3.0733887992052651E-3</c:v>
                </c:pt>
                <c:pt idx="46">
                  <c:v>7.6353851328624283E-3</c:v>
                </c:pt>
                <c:pt idx="48">
                  <c:v>3.7398522302289519E-3</c:v>
                </c:pt>
                <c:pt idx="49">
                  <c:v>5.1475319422741063E-3</c:v>
                </c:pt>
                <c:pt idx="51">
                  <c:v>3.8663484486873506E-3</c:v>
                </c:pt>
                <c:pt idx="52">
                  <c:v>4.1398088464103134E-3</c:v>
                </c:pt>
              </c:numCache>
            </c:numRef>
          </c:val>
        </c:ser>
        <c:ser>
          <c:idx val="24"/>
          <c:order val="24"/>
          <c:tx>
            <c:strRef>
              <c:f>'saliva-7'!$A$25</c:f>
              <c:strCache>
                <c:ptCount val="1"/>
                <c:pt idx="0">
                  <c:v>Megasphaera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val>
            <c:numRef>
              <c:f>'saliva-7'!$B$25:$BB$25</c:f>
              <c:numCache>
                <c:formatCode>0.0%</c:formatCode>
                <c:ptCount val="53"/>
                <c:pt idx="0">
                  <c:v>1.6408685664278291E-4</c:v>
                </c:pt>
                <c:pt idx="1">
                  <c:v>8.1982932208265417E-3</c:v>
                </c:pt>
                <c:pt idx="3">
                  <c:v>0</c:v>
                </c:pt>
                <c:pt idx="4">
                  <c:v>8.1496271545576789E-5</c:v>
                </c:pt>
                <c:pt idx="6">
                  <c:v>2.614305750350631E-2</c:v>
                </c:pt>
                <c:pt idx="7">
                  <c:v>0</c:v>
                </c:pt>
                <c:pt idx="9">
                  <c:v>1.1994784876140808E-3</c:v>
                </c:pt>
                <c:pt idx="10">
                  <c:v>2.9109179360395565E-3</c:v>
                </c:pt>
                <c:pt idx="12">
                  <c:v>3.8031076822775184E-4</c:v>
                </c:pt>
                <c:pt idx="13">
                  <c:v>4.6399031672382492E-3</c:v>
                </c:pt>
                <c:pt idx="15">
                  <c:v>0</c:v>
                </c:pt>
                <c:pt idx="16">
                  <c:v>3.4143924693447833E-2</c:v>
                </c:pt>
                <c:pt idx="18">
                  <c:v>1.2225686166636101E-4</c:v>
                </c:pt>
                <c:pt idx="19">
                  <c:v>6.4282106616465407E-4</c:v>
                </c:pt>
                <c:pt idx="21">
                  <c:v>1.4980670103092784E-2</c:v>
                </c:pt>
                <c:pt idx="22">
                  <c:v>2.9916234543278817E-4</c:v>
                </c:pt>
                <c:pt idx="24">
                  <c:v>1.8333005958226936E-3</c:v>
                </c:pt>
                <c:pt idx="25">
                  <c:v>7.1638369510709934E-5</c:v>
                </c:pt>
                <c:pt idx="27">
                  <c:v>0</c:v>
                </c:pt>
                <c:pt idx="28">
                  <c:v>0</c:v>
                </c:pt>
                <c:pt idx="30">
                  <c:v>5.945745076179859E-4</c:v>
                </c:pt>
                <c:pt idx="31">
                  <c:v>4.4979137691237833E-2</c:v>
                </c:pt>
                <c:pt idx="33">
                  <c:v>1.040474828375286E-2</c:v>
                </c:pt>
                <c:pt idx="34">
                  <c:v>5.3055460132066107E-3</c:v>
                </c:pt>
                <c:pt idx="36">
                  <c:v>1.2508291481095423E-2</c:v>
                </c:pt>
                <c:pt idx="37">
                  <c:v>4.9185563717662091E-3</c:v>
                </c:pt>
                <c:pt idx="39">
                  <c:v>5.0020448611067421E-3</c:v>
                </c:pt>
                <c:pt idx="40">
                  <c:v>1.0984484415762735E-3</c:v>
                </c:pt>
                <c:pt idx="42">
                  <c:v>5.0853156257880134E-3</c:v>
                </c:pt>
                <c:pt idx="43">
                  <c:v>8.8127911368500564E-4</c:v>
                </c:pt>
                <c:pt idx="45">
                  <c:v>2.1420588600521546E-3</c:v>
                </c:pt>
                <c:pt idx="46">
                  <c:v>4.4063235788765554E-3</c:v>
                </c:pt>
                <c:pt idx="48">
                  <c:v>0</c:v>
                </c:pt>
                <c:pt idx="49">
                  <c:v>1.5320035542482459E-4</c:v>
                </c:pt>
                <c:pt idx="51">
                  <c:v>4.0572792362768492E-3</c:v>
                </c:pt>
                <c:pt idx="52">
                  <c:v>7.4460991331406975E-3</c:v>
                </c:pt>
              </c:numCache>
            </c:numRef>
          </c:val>
        </c:ser>
        <c:ser>
          <c:idx val="25"/>
          <c:order val="25"/>
          <c:tx>
            <c:strRef>
              <c:f>'saliva-7'!$A$26</c:f>
              <c:strCache>
                <c:ptCount val="1"/>
                <c:pt idx="0">
                  <c:v>Unclassified</c:v>
                </c:pt>
              </c:strCache>
            </c:strRef>
          </c:tx>
          <c:spPr>
            <a:solidFill>
              <a:schemeClr val="bg2"/>
            </a:solidFill>
            <a:ln>
              <a:noFill/>
            </a:ln>
            <a:effectLst/>
          </c:spPr>
          <c:invertIfNegative val="0"/>
          <c:val>
            <c:numRef>
              <c:f>'saliva-7'!$B$26:$BB$26</c:f>
              <c:numCache>
                <c:formatCode>0.0%</c:formatCode>
                <c:ptCount val="53"/>
                <c:pt idx="0">
                  <c:v>5.371109774107094E-2</c:v>
                </c:pt>
                <c:pt idx="1">
                  <c:v>1.7115734969795762E-2</c:v>
                </c:pt>
                <c:pt idx="3">
                  <c:v>6.1827348825183412E-2</c:v>
                </c:pt>
                <c:pt idx="4">
                  <c:v>5.3257813455034435E-2</c:v>
                </c:pt>
                <c:pt idx="6">
                  <c:v>1.8569424964936885E-2</c:v>
                </c:pt>
                <c:pt idx="7">
                  <c:v>4.8230419129135253E-3</c:v>
                </c:pt>
                <c:pt idx="9">
                  <c:v>2.2998696219035202E-2</c:v>
                </c:pt>
                <c:pt idx="10">
                  <c:v>8.4137491027992655E-3</c:v>
                </c:pt>
                <c:pt idx="12">
                  <c:v>2.3361947191133325E-2</c:v>
                </c:pt>
                <c:pt idx="13">
                  <c:v>3.2328020980431714E-2</c:v>
                </c:pt>
                <c:pt idx="15">
                  <c:v>0.21435602332096615</c:v>
                </c:pt>
                <c:pt idx="16">
                  <c:v>3.6868832831014407E-2</c:v>
                </c:pt>
                <c:pt idx="18">
                  <c:v>0.11846689895470383</c:v>
                </c:pt>
                <c:pt idx="19">
                  <c:v>4.6237200973414758E-2</c:v>
                </c:pt>
                <c:pt idx="21">
                  <c:v>6.0889175257731958E-2</c:v>
                </c:pt>
                <c:pt idx="22">
                  <c:v>2.3135221380135622E-2</c:v>
                </c:pt>
                <c:pt idx="24">
                  <c:v>7.0713022981732473E-2</c:v>
                </c:pt>
                <c:pt idx="25">
                  <c:v>0.13249516441005801</c:v>
                </c:pt>
                <c:pt idx="27">
                  <c:v>3.3664287930499533E-2</c:v>
                </c:pt>
                <c:pt idx="28">
                  <c:v>1.5444015444015444E-3</c:v>
                </c:pt>
                <c:pt idx="30">
                  <c:v>2.6904496469713862E-2</c:v>
                </c:pt>
                <c:pt idx="31">
                  <c:v>2.141863699582754E-2</c:v>
                </c:pt>
                <c:pt idx="33">
                  <c:v>5.9496567505720827E-2</c:v>
                </c:pt>
                <c:pt idx="34">
                  <c:v>2.095499828237719E-2</c:v>
                </c:pt>
                <c:pt idx="36">
                  <c:v>5.3278688524590161E-2</c:v>
                </c:pt>
                <c:pt idx="37">
                  <c:v>5.2443308847013731E-2</c:v>
                </c:pt>
                <c:pt idx="39">
                  <c:v>5.0649636643911033E-2</c:v>
                </c:pt>
                <c:pt idx="40">
                  <c:v>1.3490319923108609E-2</c:v>
                </c:pt>
                <c:pt idx="42">
                  <c:v>1.5466083886694125E-2</c:v>
                </c:pt>
                <c:pt idx="43">
                  <c:v>1.1372697133744596E-2</c:v>
                </c:pt>
                <c:pt idx="45">
                  <c:v>4.9391531106419966E-2</c:v>
                </c:pt>
                <c:pt idx="46">
                  <c:v>1.6784392869155736E-2</c:v>
                </c:pt>
                <c:pt idx="48">
                  <c:v>2.7547204232418132E-2</c:v>
                </c:pt>
                <c:pt idx="49">
                  <c:v>2.5707019640285565E-2</c:v>
                </c:pt>
                <c:pt idx="51">
                  <c:v>1.6420047732696896E-2</c:v>
                </c:pt>
                <c:pt idx="52">
                  <c:v>1.0585685707935097E-2</c:v>
                </c:pt>
              </c:numCache>
            </c:numRef>
          </c:val>
        </c:ser>
        <c:ser>
          <c:idx val="26"/>
          <c:order val="26"/>
          <c:tx>
            <c:strRef>
              <c:f>'saliva-7'!$A$27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'saliva-7'!$B$27:$BB$27</c:f>
              <c:numCache>
                <c:formatCode>0.0%</c:formatCode>
                <c:ptCount val="53"/>
                <c:pt idx="0">
                  <c:v>7.3182738062680996E-2</c:v>
                </c:pt>
                <c:pt idx="1">
                  <c:v>5.3504650493815337E-2</c:v>
                </c:pt>
                <c:pt idx="3">
                  <c:v>0.12720985100675489</c:v>
                </c:pt>
                <c:pt idx="4">
                  <c:v>0.13153498227456098</c:v>
                </c:pt>
                <c:pt idx="6">
                  <c:v>4.196353436185124E-2</c:v>
                </c:pt>
                <c:pt idx="7">
                  <c:v>1.9631818490591663E-2</c:v>
                </c:pt>
                <c:pt idx="9">
                  <c:v>8.6936114732724681E-2</c:v>
                </c:pt>
                <c:pt idx="10">
                  <c:v>5.1638886673578452E-2</c:v>
                </c:pt>
                <c:pt idx="12">
                  <c:v>0.11800499837009677</c:v>
                </c:pt>
                <c:pt idx="13">
                  <c:v>0.13047205971353648</c:v>
                </c:pt>
                <c:pt idx="15">
                  <c:v>0.38017717876883511</c:v>
                </c:pt>
                <c:pt idx="16">
                  <c:v>3.6455967961686153E-2</c:v>
                </c:pt>
                <c:pt idx="18">
                  <c:v>0.2517880066018704</c:v>
                </c:pt>
                <c:pt idx="19">
                  <c:v>0.1007851600165296</c:v>
                </c:pt>
                <c:pt idx="21">
                  <c:v>0.10094501718213046</c:v>
                </c:pt>
                <c:pt idx="22">
                  <c:v>6.0530514559234153E-2</c:v>
                </c:pt>
                <c:pt idx="24">
                  <c:v>7.1629673279643702E-2</c:v>
                </c:pt>
                <c:pt idx="25">
                  <c:v>7.0921985815602856E-2</c:v>
                </c:pt>
                <c:pt idx="27">
                  <c:v>0.1883338504498909</c:v>
                </c:pt>
                <c:pt idx="28">
                  <c:v>9.6138996138996138E-2</c:v>
                </c:pt>
                <c:pt idx="30">
                  <c:v>5.1430694908955805E-2</c:v>
                </c:pt>
                <c:pt idx="31">
                  <c:v>5.7162726008344933E-2</c:v>
                </c:pt>
                <c:pt idx="33">
                  <c:v>5.9353546910755152E-2</c:v>
                </c:pt>
                <c:pt idx="34">
                  <c:v>2.7443795564716187E-2</c:v>
                </c:pt>
                <c:pt idx="36">
                  <c:v>3.5037430114659332E-2</c:v>
                </c:pt>
                <c:pt idx="37">
                  <c:v>9.284573618652181E-2</c:v>
                </c:pt>
                <c:pt idx="39">
                  <c:v>4.6119482807437037E-2</c:v>
                </c:pt>
                <c:pt idx="40">
                  <c:v>2.7873129204997928E-2</c:v>
                </c:pt>
                <c:pt idx="42">
                  <c:v>2.9755400521139782E-2</c:v>
                </c:pt>
                <c:pt idx="43">
                  <c:v>2.1822149481723941E-2</c:v>
                </c:pt>
                <c:pt idx="45">
                  <c:v>0.12141437973426045</c:v>
                </c:pt>
                <c:pt idx="46">
                  <c:v>9.1355533131516994E-2</c:v>
                </c:pt>
                <c:pt idx="48">
                  <c:v>2.2074249749156248E-2</c:v>
                </c:pt>
                <c:pt idx="49">
                  <c:v>2.4266936299292226E-2</c:v>
                </c:pt>
                <c:pt idx="51">
                  <c:v>3.3269689737470173E-2</c:v>
                </c:pt>
                <c:pt idx="52">
                  <c:v>2.0143365192264957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"/>
        <c:overlap val="100"/>
        <c:axId val="818893904"/>
        <c:axId val="818894464"/>
      </c:barChart>
      <c:catAx>
        <c:axId val="818893904"/>
        <c:scaling>
          <c:orientation val="minMax"/>
        </c:scaling>
        <c:delete val="1"/>
        <c:axPos val="b"/>
        <c:majorTickMark val="none"/>
        <c:minorTickMark val="none"/>
        <c:tickLblPos val="nextTo"/>
        <c:crossAx val="818894464"/>
        <c:crosses val="autoZero"/>
        <c:auto val="1"/>
        <c:lblAlgn val="ctr"/>
        <c:lblOffset val="100"/>
        <c:noMultiLvlLbl val="0"/>
      </c:catAx>
      <c:valAx>
        <c:axId val="8188944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8893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25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26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8.088643258371464E-2"/>
          <c:y val="0.61446561101598696"/>
          <c:w val="0.85857273230693976"/>
          <c:h val="0.2811634732319544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37146" cy="4660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1654" y="1"/>
            <a:ext cx="3037146" cy="4660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A43211-9CA8-4003-AFBF-90BFC2695101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44638" y="1162050"/>
            <a:ext cx="39211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880" y="4473813"/>
            <a:ext cx="5608640" cy="36605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30312"/>
            <a:ext cx="3037146" cy="4660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1654" y="8830312"/>
            <a:ext cx="3037146" cy="4660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4F5DA0-2D01-4943-B77F-469DF49C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0918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272454"/>
            <a:ext cx="7772400" cy="156802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145280"/>
            <a:ext cx="6400800" cy="18694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92948"/>
            <a:ext cx="2057400" cy="624162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92948"/>
            <a:ext cx="6019800" cy="624162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700694"/>
            <a:ext cx="7772400" cy="145288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100495"/>
            <a:ext cx="7772400" cy="16001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706880"/>
            <a:ext cx="4038600" cy="48276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706880"/>
            <a:ext cx="4038600" cy="48276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37454"/>
            <a:ext cx="4040188" cy="6824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319867"/>
            <a:ext cx="4040188" cy="42147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637454"/>
            <a:ext cx="4041775" cy="6824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319867"/>
            <a:ext cx="4041775" cy="42147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91253"/>
            <a:ext cx="3008313" cy="123952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91254"/>
            <a:ext cx="5111750" cy="62433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530774"/>
            <a:ext cx="3008313" cy="50038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120640"/>
            <a:ext cx="5486400" cy="60452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53627"/>
            <a:ext cx="5486400" cy="438912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725161"/>
            <a:ext cx="5486400" cy="8585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92947"/>
            <a:ext cx="8229600" cy="1219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706880"/>
            <a:ext cx="8229600" cy="48276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780107"/>
            <a:ext cx="21336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9396DE-199B-448C-98FD-E02F7B673999}" type="datetimeFigureOut">
              <a:rPr lang="en-US" smtClean="0"/>
              <a:t>9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780107"/>
            <a:ext cx="28956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780107"/>
            <a:ext cx="21336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B9F1A9-1D32-466F-85A1-424E90A744A6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7355582"/>
              </p:ext>
            </p:extLst>
          </p:nvPr>
        </p:nvGraphicFramePr>
        <p:xfrm>
          <a:off x="1080932" y="726509"/>
          <a:ext cx="7490564" cy="59623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676405" y="6576164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smtClean="0"/>
              <a:t>Fig </a:t>
            </a:r>
            <a:r>
              <a:rPr lang="en-US" smtClean="0"/>
              <a:t>S7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459697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17</a:t>
            </a:r>
            <a:endParaRPr lang="en-US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1850139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18</a:t>
            </a:r>
            <a:endParaRPr 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2240581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21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2631023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22</a:t>
            </a:r>
            <a:endParaRPr lang="en-US" sz="1000" dirty="0"/>
          </a:p>
        </p:txBody>
      </p:sp>
      <p:sp>
        <p:nvSpPr>
          <p:cNvPr id="9" name="TextBox 8"/>
          <p:cNvSpPr txBox="1"/>
          <p:nvPr/>
        </p:nvSpPr>
        <p:spPr>
          <a:xfrm>
            <a:off x="3021465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24</a:t>
            </a:r>
            <a:endParaRPr lang="en-US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3411907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26</a:t>
            </a:r>
            <a:endParaRPr lang="en-US" sz="1000" dirty="0"/>
          </a:p>
        </p:txBody>
      </p:sp>
      <p:sp>
        <p:nvSpPr>
          <p:cNvPr id="11" name="TextBox 10"/>
          <p:cNvSpPr txBox="1"/>
          <p:nvPr/>
        </p:nvSpPr>
        <p:spPr>
          <a:xfrm>
            <a:off x="3802298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30</a:t>
            </a:r>
            <a:endParaRPr lang="en-US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4174222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32</a:t>
            </a:r>
            <a:endParaRPr lang="en-US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4564667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33</a:t>
            </a:r>
            <a:endParaRPr lang="en-US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4939514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48</a:t>
            </a:r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5335239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53</a:t>
            </a:r>
            <a:endParaRPr lang="en-US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5725681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56</a:t>
            </a:r>
            <a:endParaRPr lang="en-US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6083173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69</a:t>
            </a:r>
            <a:endParaRPr lang="en-US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6490821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74</a:t>
            </a:r>
            <a:endParaRPr lang="en-US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6881263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84</a:t>
            </a:r>
            <a:endParaRPr lang="en-US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7271705" y="603398"/>
            <a:ext cx="3802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91</a:t>
            </a:r>
            <a:endParaRPr lang="en-US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7706769" y="603398"/>
            <a:ext cx="327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D</a:t>
            </a:r>
            <a:endParaRPr lang="en-US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8044316" y="603398"/>
            <a:ext cx="3289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#G</a:t>
            </a:r>
            <a:endParaRPr lang="en-US" sz="1000" dirty="0"/>
          </a:p>
        </p:txBody>
      </p:sp>
      <p:grpSp>
        <p:nvGrpSpPr>
          <p:cNvPr id="24" name="Group 23"/>
          <p:cNvGrpSpPr/>
          <p:nvPr/>
        </p:nvGrpSpPr>
        <p:grpSpPr>
          <a:xfrm rot="16200000">
            <a:off x="1414865" y="3912357"/>
            <a:ext cx="456199" cy="369332"/>
            <a:chOff x="92395" y="125897"/>
            <a:chExt cx="456199" cy="369332"/>
          </a:xfrm>
        </p:grpSpPr>
        <p:sp>
          <p:nvSpPr>
            <p:cNvPr id="25" name="TextBox 24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27" name="Group 26"/>
          <p:cNvGrpSpPr/>
          <p:nvPr/>
        </p:nvGrpSpPr>
        <p:grpSpPr>
          <a:xfrm rot="16200000">
            <a:off x="1799832" y="3912357"/>
            <a:ext cx="456199" cy="369332"/>
            <a:chOff x="92395" y="125897"/>
            <a:chExt cx="456199" cy="369332"/>
          </a:xfrm>
        </p:grpSpPr>
        <p:sp>
          <p:nvSpPr>
            <p:cNvPr id="28" name="TextBox 27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30" name="Group 29"/>
          <p:cNvGrpSpPr/>
          <p:nvPr/>
        </p:nvGrpSpPr>
        <p:grpSpPr>
          <a:xfrm rot="16200000">
            <a:off x="2184799" y="3912357"/>
            <a:ext cx="456199" cy="369332"/>
            <a:chOff x="92395" y="125897"/>
            <a:chExt cx="456199" cy="369332"/>
          </a:xfrm>
        </p:grpSpPr>
        <p:sp>
          <p:nvSpPr>
            <p:cNvPr id="31" name="TextBox 30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33" name="Group 32"/>
          <p:cNvGrpSpPr/>
          <p:nvPr/>
        </p:nvGrpSpPr>
        <p:grpSpPr>
          <a:xfrm rot="16200000">
            <a:off x="2569766" y="3912357"/>
            <a:ext cx="456199" cy="369332"/>
            <a:chOff x="92395" y="125897"/>
            <a:chExt cx="456199" cy="369332"/>
          </a:xfrm>
        </p:grpSpPr>
        <p:sp>
          <p:nvSpPr>
            <p:cNvPr id="34" name="TextBox 33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36" name="Group 35"/>
          <p:cNvGrpSpPr/>
          <p:nvPr/>
        </p:nvGrpSpPr>
        <p:grpSpPr>
          <a:xfrm rot="16200000">
            <a:off x="2954733" y="3912357"/>
            <a:ext cx="456199" cy="369332"/>
            <a:chOff x="92395" y="125897"/>
            <a:chExt cx="456199" cy="369332"/>
          </a:xfrm>
        </p:grpSpPr>
        <p:sp>
          <p:nvSpPr>
            <p:cNvPr id="37" name="TextBox 36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39" name="Group 38"/>
          <p:cNvGrpSpPr/>
          <p:nvPr/>
        </p:nvGrpSpPr>
        <p:grpSpPr>
          <a:xfrm rot="16200000">
            <a:off x="3339700" y="3912357"/>
            <a:ext cx="456199" cy="369332"/>
            <a:chOff x="92395" y="125897"/>
            <a:chExt cx="456199" cy="369332"/>
          </a:xfrm>
        </p:grpSpPr>
        <p:sp>
          <p:nvSpPr>
            <p:cNvPr id="40" name="TextBox 39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42" name="Group 41"/>
          <p:cNvGrpSpPr/>
          <p:nvPr/>
        </p:nvGrpSpPr>
        <p:grpSpPr>
          <a:xfrm rot="16200000">
            <a:off x="3724667" y="3912357"/>
            <a:ext cx="456199" cy="369332"/>
            <a:chOff x="92395" y="125897"/>
            <a:chExt cx="456199" cy="369332"/>
          </a:xfrm>
        </p:grpSpPr>
        <p:sp>
          <p:nvSpPr>
            <p:cNvPr id="43" name="TextBox 42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45" name="Group 44"/>
          <p:cNvGrpSpPr/>
          <p:nvPr/>
        </p:nvGrpSpPr>
        <p:grpSpPr>
          <a:xfrm rot="16200000">
            <a:off x="4109634" y="3912357"/>
            <a:ext cx="456199" cy="369332"/>
            <a:chOff x="92395" y="125897"/>
            <a:chExt cx="456199" cy="369332"/>
          </a:xfrm>
        </p:grpSpPr>
        <p:sp>
          <p:nvSpPr>
            <p:cNvPr id="46" name="TextBox 45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48" name="Group 47"/>
          <p:cNvGrpSpPr/>
          <p:nvPr/>
        </p:nvGrpSpPr>
        <p:grpSpPr>
          <a:xfrm rot="16200000">
            <a:off x="4494601" y="3912357"/>
            <a:ext cx="456199" cy="369332"/>
            <a:chOff x="92395" y="125897"/>
            <a:chExt cx="456199" cy="369332"/>
          </a:xfrm>
        </p:grpSpPr>
        <p:sp>
          <p:nvSpPr>
            <p:cNvPr id="49" name="TextBox 48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51" name="Group 50"/>
          <p:cNvGrpSpPr/>
          <p:nvPr/>
        </p:nvGrpSpPr>
        <p:grpSpPr>
          <a:xfrm rot="16200000">
            <a:off x="4879568" y="3912357"/>
            <a:ext cx="456199" cy="369332"/>
            <a:chOff x="92395" y="125897"/>
            <a:chExt cx="456199" cy="369332"/>
          </a:xfrm>
        </p:grpSpPr>
        <p:sp>
          <p:nvSpPr>
            <p:cNvPr id="52" name="TextBox 51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54" name="Group 53"/>
          <p:cNvGrpSpPr/>
          <p:nvPr/>
        </p:nvGrpSpPr>
        <p:grpSpPr>
          <a:xfrm rot="16200000">
            <a:off x="5264535" y="3912357"/>
            <a:ext cx="456199" cy="369332"/>
            <a:chOff x="92395" y="125897"/>
            <a:chExt cx="456199" cy="369332"/>
          </a:xfrm>
        </p:grpSpPr>
        <p:sp>
          <p:nvSpPr>
            <p:cNvPr id="55" name="TextBox 54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57" name="Group 56"/>
          <p:cNvGrpSpPr/>
          <p:nvPr/>
        </p:nvGrpSpPr>
        <p:grpSpPr>
          <a:xfrm rot="16200000">
            <a:off x="5677389" y="3912357"/>
            <a:ext cx="456199" cy="369332"/>
            <a:chOff x="92395" y="125897"/>
            <a:chExt cx="456199" cy="369332"/>
          </a:xfrm>
        </p:grpSpPr>
        <p:sp>
          <p:nvSpPr>
            <p:cNvPr id="58" name="TextBox 57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60" name="Group 59"/>
          <p:cNvGrpSpPr/>
          <p:nvPr/>
        </p:nvGrpSpPr>
        <p:grpSpPr>
          <a:xfrm rot="16200000">
            <a:off x="6060394" y="3912357"/>
            <a:ext cx="456199" cy="369332"/>
            <a:chOff x="92395" y="125897"/>
            <a:chExt cx="456199" cy="369332"/>
          </a:xfrm>
        </p:grpSpPr>
        <p:sp>
          <p:nvSpPr>
            <p:cNvPr id="61" name="TextBox 60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63" name="Group 62"/>
          <p:cNvGrpSpPr/>
          <p:nvPr/>
        </p:nvGrpSpPr>
        <p:grpSpPr>
          <a:xfrm rot="16200000">
            <a:off x="6419436" y="3912357"/>
            <a:ext cx="456199" cy="369332"/>
            <a:chOff x="92395" y="125897"/>
            <a:chExt cx="456199" cy="369332"/>
          </a:xfrm>
        </p:grpSpPr>
        <p:sp>
          <p:nvSpPr>
            <p:cNvPr id="64" name="TextBox 63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66" name="Group 65"/>
          <p:cNvGrpSpPr/>
          <p:nvPr/>
        </p:nvGrpSpPr>
        <p:grpSpPr>
          <a:xfrm rot="16200000">
            <a:off x="6816655" y="3912357"/>
            <a:ext cx="456199" cy="369332"/>
            <a:chOff x="92395" y="125897"/>
            <a:chExt cx="456199" cy="369332"/>
          </a:xfrm>
        </p:grpSpPr>
        <p:sp>
          <p:nvSpPr>
            <p:cNvPr id="67" name="TextBox 66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69" name="Group 68"/>
          <p:cNvGrpSpPr/>
          <p:nvPr/>
        </p:nvGrpSpPr>
        <p:grpSpPr>
          <a:xfrm rot="16200000">
            <a:off x="7201622" y="3912357"/>
            <a:ext cx="456199" cy="369332"/>
            <a:chOff x="92395" y="125897"/>
            <a:chExt cx="456199" cy="369332"/>
          </a:xfrm>
        </p:grpSpPr>
        <p:sp>
          <p:nvSpPr>
            <p:cNvPr id="70" name="TextBox 69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72" name="Group 71"/>
          <p:cNvGrpSpPr/>
          <p:nvPr/>
        </p:nvGrpSpPr>
        <p:grpSpPr>
          <a:xfrm rot="16200000">
            <a:off x="7586590" y="3912357"/>
            <a:ext cx="456199" cy="369332"/>
            <a:chOff x="92395" y="125897"/>
            <a:chExt cx="456199" cy="369332"/>
          </a:xfrm>
        </p:grpSpPr>
        <p:sp>
          <p:nvSpPr>
            <p:cNvPr id="73" name="TextBox 72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  <p:grpSp>
        <p:nvGrpSpPr>
          <p:cNvPr id="75" name="Group 74"/>
          <p:cNvGrpSpPr/>
          <p:nvPr/>
        </p:nvGrpSpPr>
        <p:grpSpPr>
          <a:xfrm rot="16200000">
            <a:off x="7971559" y="3912357"/>
            <a:ext cx="456199" cy="369332"/>
            <a:chOff x="92395" y="125897"/>
            <a:chExt cx="456199" cy="369332"/>
          </a:xfrm>
        </p:grpSpPr>
        <p:sp>
          <p:nvSpPr>
            <p:cNvPr id="76" name="TextBox 75"/>
            <p:cNvSpPr txBox="1"/>
            <p:nvPr/>
          </p:nvSpPr>
          <p:spPr>
            <a:xfrm>
              <a:off x="149126" y="125897"/>
              <a:ext cx="3994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p</a:t>
              </a:r>
              <a:r>
                <a:rPr lang="en-US" sz="1000" dirty="0" smtClean="0"/>
                <a:t>re-</a:t>
              </a:r>
              <a:endParaRPr lang="en-US" sz="10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92395" y="249008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 smtClean="0"/>
                <a:t>post-</a:t>
              </a:r>
              <a:endParaRPr 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394953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06</TotalTime>
  <Words>75</Words>
  <Application>Microsoft Office PowerPoint</Application>
  <PresentationFormat>Custom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hom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NBRE</dc:creator>
  <cp:lastModifiedBy>Casey Chen</cp:lastModifiedBy>
  <cp:revision>168</cp:revision>
  <cp:lastPrinted>2017-09-11T16:36:56Z</cp:lastPrinted>
  <dcterms:created xsi:type="dcterms:W3CDTF">2015-12-19T16:15:08Z</dcterms:created>
  <dcterms:modified xsi:type="dcterms:W3CDTF">2017-09-29T22:04:38Z</dcterms:modified>
</cp:coreProperties>
</file>